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82" r:id="rId3"/>
    <p:sldId id="283" r:id="rId4"/>
    <p:sldId id="279" r:id="rId5"/>
    <p:sldId id="281" r:id="rId6"/>
    <p:sldId id="285" r:id="rId7"/>
    <p:sldId id="276" r:id="rId8"/>
    <p:sldId id="277" r:id="rId9"/>
    <p:sldId id="28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14A3FDD-622A-8C4A-9C66-040DA1A0EBF6}" v="19" dt="2020-11-02T15:05:39.8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569"/>
    <p:restoredTop sz="95588"/>
  </p:normalViewPr>
  <p:slideViewPr>
    <p:cSldViewPr snapToGrid="0" snapToObjects="1">
      <p:cViewPr varScale="1">
        <p:scale>
          <a:sx n="100" d="100"/>
          <a:sy n="100" d="100"/>
        </p:scale>
        <p:origin x="16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hao Le" userId="c2d24242046cb3e5" providerId="LiveId" clId="{414A3FDD-622A-8C4A-9C66-040DA1A0EBF6}"/>
    <pc:docChg chg="undo custSel addSld modSld sldOrd">
      <pc:chgData name="Thao Le" userId="c2d24242046cb3e5" providerId="LiveId" clId="{414A3FDD-622A-8C4A-9C66-040DA1A0EBF6}" dt="2020-11-03T01:45:58.772" v="513" actId="13926"/>
      <pc:docMkLst>
        <pc:docMk/>
      </pc:docMkLst>
      <pc:sldChg chg="addSp delSp modSp mod">
        <pc:chgData name="Thao Le" userId="c2d24242046cb3e5" providerId="LiveId" clId="{414A3FDD-622A-8C4A-9C66-040DA1A0EBF6}" dt="2020-11-02T16:55:58.962" v="510" actId="1076"/>
        <pc:sldMkLst>
          <pc:docMk/>
          <pc:sldMk cId="3292672160" sldId="276"/>
        </pc:sldMkLst>
        <pc:spChg chg="mod">
          <ac:chgData name="Thao Le" userId="c2d24242046cb3e5" providerId="LiveId" clId="{414A3FDD-622A-8C4A-9C66-040DA1A0EBF6}" dt="2020-11-02T15:04:54.534" v="496" actId="1076"/>
          <ac:spMkLst>
            <pc:docMk/>
            <pc:sldMk cId="3292672160" sldId="276"/>
            <ac:spMk id="2" creationId="{3765C8EE-0043-8042-9A06-516602AAA579}"/>
          </ac:spMkLst>
        </pc:spChg>
        <pc:spChg chg="mod">
          <ac:chgData name="Thao Le" userId="c2d24242046cb3e5" providerId="LiveId" clId="{414A3FDD-622A-8C4A-9C66-040DA1A0EBF6}" dt="2020-11-02T15:04:50.467" v="495" actId="1076"/>
          <ac:spMkLst>
            <pc:docMk/>
            <pc:sldMk cId="3292672160" sldId="276"/>
            <ac:spMk id="14" creationId="{C2DE68E7-4575-2744-8011-BE0CDC4124BE}"/>
          </ac:spMkLst>
        </pc:spChg>
        <pc:spChg chg="del">
          <ac:chgData name="Thao Le" userId="c2d24242046cb3e5" providerId="LiveId" clId="{414A3FDD-622A-8C4A-9C66-040DA1A0EBF6}" dt="2020-11-02T08:12:12.681" v="4" actId="21"/>
          <ac:spMkLst>
            <pc:docMk/>
            <pc:sldMk cId="3292672160" sldId="276"/>
            <ac:spMk id="21" creationId="{A6E83DDF-47FB-7341-9A1F-3CAD38B04468}"/>
          </ac:spMkLst>
        </pc:spChg>
        <pc:spChg chg="mod">
          <ac:chgData name="Thao Le" userId="c2d24242046cb3e5" providerId="LiveId" clId="{414A3FDD-622A-8C4A-9C66-040DA1A0EBF6}" dt="2020-11-02T15:03:04.134" v="473" actId="1038"/>
          <ac:spMkLst>
            <pc:docMk/>
            <pc:sldMk cId="3292672160" sldId="276"/>
            <ac:spMk id="23" creationId="{B363008F-B2DC-274A-968D-DE5C4091BE6C}"/>
          </ac:spMkLst>
        </pc:spChg>
        <pc:spChg chg="mod">
          <ac:chgData name="Thao Le" userId="c2d24242046cb3e5" providerId="LiveId" clId="{414A3FDD-622A-8C4A-9C66-040DA1A0EBF6}" dt="2020-11-02T15:03:12.508" v="483" actId="1037"/>
          <ac:spMkLst>
            <pc:docMk/>
            <pc:sldMk cId="3292672160" sldId="276"/>
            <ac:spMk id="24" creationId="{A4BFBD6E-A141-BD46-8E77-33C02D8376F0}"/>
          </ac:spMkLst>
        </pc:spChg>
        <pc:spChg chg="mod">
          <ac:chgData name="Thao Le" userId="c2d24242046cb3e5" providerId="LiveId" clId="{414A3FDD-622A-8C4A-9C66-040DA1A0EBF6}" dt="2020-11-02T08:16:58.949" v="48" actId="1076"/>
          <ac:spMkLst>
            <pc:docMk/>
            <pc:sldMk cId="3292672160" sldId="276"/>
            <ac:spMk id="25" creationId="{9B4AB8FE-A26D-8540-B741-B3765F0A6300}"/>
          </ac:spMkLst>
        </pc:spChg>
        <pc:spChg chg="add mod">
          <ac:chgData name="Thao Le" userId="c2d24242046cb3e5" providerId="LiveId" clId="{414A3FDD-622A-8C4A-9C66-040DA1A0EBF6}" dt="2020-11-02T16:55:58.962" v="510" actId="1076"/>
          <ac:spMkLst>
            <pc:docMk/>
            <pc:sldMk cId="3292672160" sldId="276"/>
            <ac:spMk id="28" creationId="{0F7F9DE1-419A-E947-995B-5701D8E3DF55}"/>
          </ac:spMkLst>
        </pc:spChg>
        <pc:spChg chg="mod">
          <ac:chgData name="Thao Le" userId="c2d24242046cb3e5" providerId="LiveId" clId="{414A3FDD-622A-8C4A-9C66-040DA1A0EBF6}" dt="2020-11-02T15:04:33.482" v="494" actId="255"/>
          <ac:spMkLst>
            <pc:docMk/>
            <pc:sldMk cId="3292672160" sldId="276"/>
            <ac:spMk id="29" creationId="{E08BEEAB-9909-F64A-9AF9-9A166514EA92}"/>
          </ac:spMkLst>
        </pc:spChg>
        <pc:spChg chg="add mod">
          <ac:chgData name="Thao Le" userId="c2d24242046cb3e5" providerId="LiveId" clId="{414A3FDD-622A-8C4A-9C66-040DA1A0EBF6}" dt="2020-11-02T15:04:04.995" v="493" actId="1037"/>
          <ac:spMkLst>
            <pc:docMk/>
            <pc:sldMk cId="3292672160" sldId="276"/>
            <ac:spMk id="30" creationId="{33237B17-D2A5-014C-A15D-D680B10C46EA}"/>
          </ac:spMkLst>
        </pc:spChg>
        <pc:spChg chg="add mod">
          <ac:chgData name="Thao Le" userId="c2d24242046cb3e5" providerId="LiveId" clId="{414A3FDD-622A-8C4A-9C66-040DA1A0EBF6}" dt="2020-11-02T15:04:04.995" v="493" actId="1037"/>
          <ac:spMkLst>
            <pc:docMk/>
            <pc:sldMk cId="3292672160" sldId="276"/>
            <ac:spMk id="31" creationId="{5925F54F-0D4D-624B-943B-24B2C0E0C83D}"/>
          </ac:spMkLst>
        </pc:spChg>
        <pc:spChg chg="add mod">
          <ac:chgData name="Thao Le" userId="c2d24242046cb3e5" providerId="LiveId" clId="{414A3FDD-622A-8C4A-9C66-040DA1A0EBF6}" dt="2020-11-02T15:04:04.995" v="493" actId="1037"/>
          <ac:spMkLst>
            <pc:docMk/>
            <pc:sldMk cId="3292672160" sldId="276"/>
            <ac:spMk id="33" creationId="{995E0B01-48DC-4944-97FC-40C6BF4D9029}"/>
          </ac:spMkLst>
        </pc:spChg>
        <pc:spChg chg="add mod">
          <ac:chgData name="Thao Le" userId="c2d24242046cb3e5" providerId="LiveId" clId="{414A3FDD-622A-8C4A-9C66-040DA1A0EBF6}" dt="2020-11-02T15:04:04.995" v="493" actId="1037"/>
          <ac:spMkLst>
            <pc:docMk/>
            <pc:sldMk cId="3292672160" sldId="276"/>
            <ac:spMk id="34" creationId="{7E9CFE46-CE62-784D-AC70-BBC72D371888}"/>
          </ac:spMkLst>
        </pc:spChg>
        <pc:spChg chg="add mod">
          <ac:chgData name="Thao Le" userId="c2d24242046cb3e5" providerId="LiveId" clId="{414A3FDD-622A-8C4A-9C66-040DA1A0EBF6}" dt="2020-11-02T15:04:04.995" v="493" actId="1037"/>
          <ac:spMkLst>
            <pc:docMk/>
            <pc:sldMk cId="3292672160" sldId="276"/>
            <ac:spMk id="35" creationId="{09FBF3AD-43F4-4443-93F5-FC86BE112550}"/>
          </ac:spMkLst>
        </pc:spChg>
        <pc:spChg chg="add mod">
          <ac:chgData name="Thao Le" userId="c2d24242046cb3e5" providerId="LiveId" clId="{414A3FDD-622A-8C4A-9C66-040DA1A0EBF6}" dt="2020-11-02T15:04:04.995" v="493" actId="1037"/>
          <ac:spMkLst>
            <pc:docMk/>
            <pc:sldMk cId="3292672160" sldId="276"/>
            <ac:spMk id="36" creationId="{F4612B5C-79A4-F44C-B961-2075D7064937}"/>
          </ac:spMkLst>
        </pc:spChg>
        <pc:picChg chg="mod">
          <ac:chgData name="Thao Le" userId="c2d24242046cb3e5" providerId="LiveId" clId="{414A3FDD-622A-8C4A-9C66-040DA1A0EBF6}" dt="2020-11-02T15:03:12.508" v="483" actId="1037"/>
          <ac:picMkLst>
            <pc:docMk/>
            <pc:sldMk cId="3292672160" sldId="276"/>
            <ac:picMk id="7" creationId="{9347A85D-F746-D34D-97F4-A45D53516F1D}"/>
          </ac:picMkLst>
        </pc:picChg>
        <pc:picChg chg="mod">
          <ac:chgData name="Thao Le" userId="c2d24242046cb3e5" providerId="LiveId" clId="{414A3FDD-622A-8C4A-9C66-040DA1A0EBF6}" dt="2020-11-02T08:15:45.326" v="41" actId="14100"/>
          <ac:picMkLst>
            <pc:docMk/>
            <pc:sldMk cId="3292672160" sldId="276"/>
            <ac:picMk id="9" creationId="{63957CED-EB6B-954C-87DF-8687305CE1E2}"/>
          </ac:picMkLst>
        </pc:picChg>
        <pc:picChg chg="mod">
          <ac:chgData name="Thao Le" userId="c2d24242046cb3e5" providerId="LiveId" clId="{414A3FDD-622A-8C4A-9C66-040DA1A0EBF6}" dt="2020-11-02T15:03:12.508" v="483" actId="1037"/>
          <ac:picMkLst>
            <pc:docMk/>
            <pc:sldMk cId="3292672160" sldId="276"/>
            <ac:picMk id="10" creationId="{1792008F-EE32-F143-8B41-9471FFDBCF7F}"/>
          </ac:picMkLst>
        </pc:picChg>
        <pc:picChg chg="mod">
          <ac:chgData name="Thao Le" userId="c2d24242046cb3e5" providerId="LiveId" clId="{414A3FDD-622A-8C4A-9C66-040DA1A0EBF6}" dt="2020-11-02T15:03:04.134" v="473" actId="1038"/>
          <ac:picMkLst>
            <pc:docMk/>
            <pc:sldMk cId="3292672160" sldId="276"/>
            <ac:picMk id="12" creationId="{43DFA92B-783E-D941-9BCE-89A9F1FEBFA5}"/>
          </ac:picMkLst>
        </pc:picChg>
        <pc:picChg chg="mod">
          <ac:chgData name="Thao Le" userId="c2d24242046cb3e5" providerId="LiveId" clId="{414A3FDD-622A-8C4A-9C66-040DA1A0EBF6}" dt="2020-11-02T15:03:04.134" v="473" actId="1038"/>
          <ac:picMkLst>
            <pc:docMk/>
            <pc:sldMk cId="3292672160" sldId="276"/>
            <ac:picMk id="15" creationId="{0E2AF198-D4E3-464F-B158-C5DA7F695168}"/>
          </ac:picMkLst>
        </pc:picChg>
        <pc:picChg chg="mod">
          <ac:chgData name="Thao Le" userId="c2d24242046cb3e5" providerId="LiveId" clId="{414A3FDD-622A-8C4A-9C66-040DA1A0EBF6}" dt="2020-11-02T15:03:04.134" v="473" actId="1038"/>
          <ac:picMkLst>
            <pc:docMk/>
            <pc:sldMk cId="3292672160" sldId="276"/>
            <ac:picMk id="18" creationId="{6460C849-BE8E-C040-99F6-46AF9ADFA20B}"/>
          </ac:picMkLst>
        </pc:picChg>
        <pc:picChg chg="mod">
          <ac:chgData name="Thao Le" userId="c2d24242046cb3e5" providerId="LiveId" clId="{414A3FDD-622A-8C4A-9C66-040DA1A0EBF6}" dt="2020-11-02T15:03:12.508" v="483" actId="1037"/>
          <ac:picMkLst>
            <pc:docMk/>
            <pc:sldMk cId="3292672160" sldId="276"/>
            <ac:picMk id="20" creationId="{4198D839-8E9C-3540-B986-D6B730C48AF4}"/>
          </ac:picMkLst>
        </pc:picChg>
        <pc:picChg chg="mod">
          <ac:chgData name="Thao Le" userId="c2d24242046cb3e5" providerId="LiveId" clId="{414A3FDD-622A-8C4A-9C66-040DA1A0EBF6}" dt="2020-11-02T16:55:55.212" v="509" actId="1076"/>
          <ac:picMkLst>
            <pc:docMk/>
            <pc:sldMk cId="3292672160" sldId="276"/>
            <ac:picMk id="22" creationId="{87F3DC44-A9A1-0F4C-913D-0EA15DD6668C}"/>
          </ac:picMkLst>
        </pc:picChg>
        <pc:picChg chg="mod">
          <ac:chgData name="Thao Le" userId="c2d24242046cb3e5" providerId="LiveId" clId="{414A3FDD-622A-8C4A-9C66-040DA1A0EBF6}" dt="2020-11-02T08:15:39.692" v="40" actId="14100"/>
          <ac:picMkLst>
            <pc:docMk/>
            <pc:sldMk cId="3292672160" sldId="276"/>
            <ac:picMk id="26" creationId="{AD35F45E-74EF-0A4F-A636-86CE773B4F3A}"/>
          </ac:picMkLst>
        </pc:picChg>
        <pc:picChg chg="mod">
          <ac:chgData name="Thao Le" userId="c2d24242046cb3e5" providerId="LiveId" clId="{414A3FDD-622A-8C4A-9C66-040DA1A0EBF6}" dt="2020-11-02T08:14:26.200" v="28" actId="1076"/>
          <ac:picMkLst>
            <pc:docMk/>
            <pc:sldMk cId="3292672160" sldId="276"/>
            <ac:picMk id="32" creationId="{7D8881DD-4AC4-1748-9FC2-41573584AA29}"/>
          </ac:picMkLst>
        </pc:picChg>
      </pc:sldChg>
      <pc:sldChg chg="addSp delSp modSp mod">
        <pc:chgData name="Thao Le" userId="c2d24242046cb3e5" providerId="LiveId" clId="{414A3FDD-622A-8C4A-9C66-040DA1A0EBF6}" dt="2020-11-02T15:02:18.892" v="449" actId="14100"/>
        <pc:sldMkLst>
          <pc:docMk/>
          <pc:sldMk cId="2148405265" sldId="279"/>
        </pc:sldMkLst>
        <pc:spChg chg="mod">
          <ac:chgData name="Thao Le" userId="c2d24242046cb3e5" providerId="LiveId" clId="{414A3FDD-622A-8C4A-9C66-040DA1A0EBF6}" dt="2020-11-02T09:53:38.535" v="329" actId="1076"/>
          <ac:spMkLst>
            <pc:docMk/>
            <pc:sldMk cId="2148405265" sldId="279"/>
            <ac:spMk id="2" creationId="{3765C8EE-0043-8042-9A06-516602AAA579}"/>
          </ac:spMkLst>
        </pc:spChg>
        <pc:spChg chg="mod">
          <ac:chgData name="Thao Le" userId="c2d24242046cb3e5" providerId="LiveId" clId="{414A3FDD-622A-8C4A-9C66-040DA1A0EBF6}" dt="2020-11-02T09:53:32.320" v="328" actId="1076"/>
          <ac:spMkLst>
            <pc:docMk/>
            <pc:sldMk cId="2148405265" sldId="279"/>
            <ac:spMk id="14" creationId="{C2DE68E7-4575-2744-8011-BE0CDC4124BE}"/>
          </ac:spMkLst>
        </pc:spChg>
        <pc:spChg chg="add mod">
          <ac:chgData name="Thao Le" userId="c2d24242046cb3e5" providerId="LiveId" clId="{414A3FDD-622A-8C4A-9C66-040DA1A0EBF6}" dt="2020-11-02T15:02:18.892" v="449" actId="14100"/>
          <ac:spMkLst>
            <pc:docMk/>
            <pc:sldMk cId="2148405265" sldId="279"/>
            <ac:spMk id="19" creationId="{D93AA976-CDE9-4744-9DCE-A0897D2FE756}"/>
          </ac:spMkLst>
        </pc:spChg>
        <pc:spChg chg="del">
          <ac:chgData name="Thao Le" userId="c2d24242046cb3e5" providerId="LiveId" clId="{414A3FDD-622A-8C4A-9C66-040DA1A0EBF6}" dt="2020-11-02T09:32:04.498" v="55" actId="21"/>
          <ac:spMkLst>
            <pc:docMk/>
            <pc:sldMk cId="2148405265" sldId="279"/>
            <ac:spMk id="21" creationId="{A6E83DDF-47FB-7341-9A1F-3CAD38B04468}"/>
          </ac:spMkLst>
        </pc:spChg>
        <pc:spChg chg="mod">
          <ac:chgData name="Thao Le" userId="c2d24242046cb3e5" providerId="LiveId" clId="{414A3FDD-622A-8C4A-9C66-040DA1A0EBF6}" dt="2020-11-02T10:39:32.886" v="390" actId="1038"/>
          <ac:spMkLst>
            <pc:docMk/>
            <pc:sldMk cId="2148405265" sldId="279"/>
            <ac:spMk id="23" creationId="{B363008F-B2DC-274A-968D-DE5C4091BE6C}"/>
          </ac:spMkLst>
        </pc:spChg>
        <pc:spChg chg="mod">
          <ac:chgData name="Thao Le" userId="c2d24242046cb3e5" providerId="LiveId" clId="{414A3FDD-622A-8C4A-9C66-040DA1A0EBF6}" dt="2020-11-02T10:30:18.070" v="376" actId="1038"/>
          <ac:spMkLst>
            <pc:docMk/>
            <pc:sldMk cId="2148405265" sldId="279"/>
            <ac:spMk id="24" creationId="{A4BFBD6E-A141-BD46-8E77-33C02D8376F0}"/>
          </ac:spMkLst>
        </pc:spChg>
        <pc:spChg chg="mod">
          <ac:chgData name="Thao Le" userId="c2d24242046cb3e5" providerId="LiveId" clId="{414A3FDD-622A-8C4A-9C66-040DA1A0EBF6}" dt="2020-11-02T10:39:47.421" v="401" actId="1035"/>
          <ac:spMkLst>
            <pc:docMk/>
            <pc:sldMk cId="2148405265" sldId="279"/>
            <ac:spMk id="25" creationId="{9B4AB8FE-A26D-8540-B741-B3765F0A6300}"/>
          </ac:spMkLst>
        </pc:spChg>
        <pc:spChg chg="add mod">
          <ac:chgData name="Thao Le" userId="c2d24242046cb3e5" providerId="LiveId" clId="{414A3FDD-622A-8C4A-9C66-040DA1A0EBF6}" dt="2020-11-02T09:53:22.865" v="327" actId="14100"/>
          <ac:spMkLst>
            <pc:docMk/>
            <pc:sldMk cId="2148405265" sldId="279"/>
            <ac:spMk id="26" creationId="{CD35B20B-FF5C-9547-8321-67099B6963A9}"/>
          </ac:spMkLst>
        </pc:spChg>
        <pc:spChg chg="add mod">
          <ac:chgData name="Thao Le" userId="c2d24242046cb3e5" providerId="LiveId" clId="{414A3FDD-622A-8C4A-9C66-040DA1A0EBF6}" dt="2020-11-02T10:39:32.886" v="390" actId="1038"/>
          <ac:spMkLst>
            <pc:docMk/>
            <pc:sldMk cId="2148405265" sldId="279"/>
            <ac:spMk id="27" creationId="{41CBF69C-7CB2-A14C-9074-A6CE60B367BF}"/>
          </ac:spMkLst>
        </pc:spChg>
        <pc:spChg chg="add mod">
          <ac:chgData name="Thao Le" userId="c2d24242046cb3e5" providerId="LiveId" clId="{414A3FDD-622A-8C4A-9C66-040DA1A0EBF6}" dt="2020-11-02T10:39:32.886" v="390" actId="1038"/>
          <ac:spMkLst>
            <pc:docMk/>
            <pc:sldMk cId="2148405265" sldId="279"/>
            <ac:spMk id="28" creationId="{2059942E-B2A2-494D-88A9-AA69ED2FA755}"/>
          </ac:spMkLst>
        </pc:spChg>
        <pc:spChg chg="add mod">
          <ac:chgData name="Thao Le" userId="c2d24242046cb3e5" providerId="LiveId" clId="{414A3FDD-622A-8C4A-9C66-040DA1A0EBF6}" dt="2020-11-02T10:39:32.886" v="390" actId="1038"/>
          <ac:spMkLst>
            <pc:docMk/>
            <pc:sldMk cId="2148405265" sldId="279"/>
            <ac:spMk id="30" creationId="{21B07121-CEF8-AB4A-B04B-8A061432576C}"/>
          </ac:spMkLst>
        </pc:spChg>
        <pc:spChg chg="add del mod">
          <ac:chgData name="Thao Le" userId="c2d24242046cb3e5" providerId="LiveId" clId="{414A3FDD-622A-8C4A-9C66-040DA1A0EBF6}" dt="2020-11-02T10:29:42.852" v="364" actId="478"/>
          <ac:spMkLst>
            <pc:docMk/>
            <pc:sldMk cId="2148405265" sldId="279"/>
            <ac:spMk id="32" creationId="{A9E3EE31-BCED-2045-BF5E-FD18043BC612}"/>
          </ac:spMkLst>
        </pc:spChg>
        <pc:spChg chg="add mod">
          <ac:chgData name="Thao Le" userId="c2d24242046cb3e5" providerId="LiveId" clId="{414A3FDD-622A-8C4A-9C66-040DA1A0EBF6}" dt="2020-11-02T10:40:42.455" v="427" actId="14100"/>
          <ac:spMkLst>
            <pc:docMk/>
            <pc:sldMk cId="2148405265" sldId="279"/>
            <ac:spMk id="33" creationId="{471C3E19-2C13-1B46-AEDD-A1748BF49205}"/>
          </ac:spMkLst>
        </pc:spChg>
        <pc:spChg chg="add mod">
          <ac:chgData name="Thao Le" userId="c2d24242046cb3e5" providerId="LiveId" clId="{414A3FDD-622A-8C4A-9C66-040DA1A0EBF6}" dt="2020-11-02T10:41:07.183" v="438" actId="20577"/>
          <ac:spMkLst>
            <pc:docMk/>
            <pc:sldMk cId="2148405265" sldId="279"/>
            <ac:spMk id="34" creationId="{1C392FE7-8AE9-804A-92A0-9B8781A6BAE9}"/>
          </ac:spMkLst>
        </pc:spChg>
        <pc:spChg chg="mod">
          <ac:chgData name="Thao Le" userId="c2d24242046cb3e5" providerId="LiveId" clId="{414A3FDD-622A-8C4A-9C66-040DA1A0EBF6}" dt="2020-11-02T10:40:02.614" v="411" actId="1037"/>
          <ac:spMkLst>
            <pc:docMk/>
            <pc:sldMk cId="2148405265" sldId="279"/>
            <ac:spMk id="36" creationId="{71CC86DA-EC22-2A45-81B3-6C6F4E11EC3D}"/>
          </ac:spMkLst>
        </pc:spChg>
        <pc:picChg chg="mod">
          <ac:chgData name="Thao Le" userId="c2d24242046cb3e5" providerId="LiveId" clId="{414A3FDD-622A-8C4A-9C66-040DA1A0EBF6}" dt="2020-11-02T10:39:32.886" v="390" actId="1038"/>
          <ac:picMkLst>
            <pc:docMk/>
            <pc:sldMk cId="2148405265" sldId="279"/>
            <ac:picMk id="4" creationId="{1C10E903-22BE-E248-9300-A9DDC616A5D0}"/>
          </ac:picMkLst>
        </pc:picChg>
        <pc:picChg chg="add mod">
          <ac:chgData name="Thao Le" userId="c2d24242046cb3e5" providerId="LiveId" clId="{414A3FDD-622A-8C4A-9C66-040DA1A0EBF6}" dt="2020-11-02T10:39:47.421" v="401" actId="1035"/>
          <ac:picMkLst>
            <pc:docMk/>
            <pc:sldMk cId="2148405265" sldId="279"/>
            <ac:picMk id="5" creationId="{82A47415-6F95-874F-BACA-7A45197A367A}"/>
          </ac:picMkLst>
        </pc:picChg>
        <pc:picChg chg="mod">
          <ac:chgData name="Thao Le" userId="c2d24242046cb3e5" providerId="LiveId" clId="{414A3FDD-622A-8C4A-9C66-040DA1A0EBF6}" dt="2020-11-02T10:39:32.886" v="390" actId="1038"/>
          <ac:picMkLst>
            <pc:docMk/>
            <pc:sldMk cId="2148405265" sldId="279"/>
            <ac:picMk id="6" creationId="{AE499061-7159-CD4E-AF38-84BC9E06F814}"/>
          </ac:picMkLst>
        </pc:picChg>
        <pc:picChg chg="mod">
          <ac:chgData name="Thao Le" userId="c2d24242046cb3e5" providerId="LiveId" clId="{414A3FDD-622A-8C4A-9C66-040DA1A0EBF6}" dt="2020-11-02T10:30:18.070" v="376" actId="1038"/>
          <ac:picMkLst>
            <pc:docMk/>
            <pc:sldMk cId="2148405265" sldId="279"/>
            <ac:picMk id="8" creationId="{6CF72788-B002-1F4A-AEF1-CF22CD707FA7}"/>
          </ac:picMkLst>
        </pc:picChg>
        <pc:picChg chg="add mod">
          <ac:chgData name="Thao Le" userId="c2d24242046cb3e5" providerId="LiveId" clId="{414A3FDD-622A-8C4A-9C66-040DA1A0EBF6}" dt="2020-11-02T10:39:47.421" v="401" actId="1035"/>
          <ac:picMkLst>
            <pc:docMk/>
            <pc:sldMk cId="2148405265" sldId="279"/>
            <ac:picMk id="9" creationId="{7A4DB7AE-CD50-314D-B4F0-8E20ED4131EE}"/>
          </ac:picMkLst>
        </pc:picChg>
        <pc:picChg chg="mod">
          <ac:chgData name="Thao Le" userId="c2d24242046cb3e5" providerId="LiveId" clId="{414A3FDD-622A-8C4A-9C66-040DA1A0EBF6}" dt="2020-11-02T10:30:18.070" v="376" actId="1038"/>
          <ac:picMkLst>
            <pc:docMk/>
            <pc:sldMk cId="2148405265" sldId="279"/>
            <ac:picMk id="10" creationId="{CCE3E03D-4458-5A49-9D2B-D010350C1DCD}"/>
          </ac:picMkLst>
        </pc:picChg>
        <pc:picChg chg="del">
          <ac:chgData name="Thao Le" userId="c2d24242046cb3e5" providerId="LiveId" clId="{414A3FDD-622A-8C4A-9C66-040DA1A0EBF6}" dt="2020-11-02T09:33:03.611" v="68" actId="478"/>
          <ac:picMkLst>
            <pc:docMk/>
            <pc:sldMk cId="2148405265" sldId="279"/>
            <ac:picMk id="12" creationId="{97E4E861-239B-9340-81B3-255095685FED}"/>
          </ac:picMkLst>
        </pc:picChg>
        <pc:picChg chg="add mod">
          <ac:chgData name="Thao Le" userId="c2d24242046cb3e5" providerId="LiveId" clId="{414A3FDD-622A-8C4A-9C66-040DA1A0EBF6}" dt="2020-11-02T10:39:47.421" v="401" actId="1035"/>
          <ac:picMkLst>
            <pc:docMk/>
            <pc:sldMk cId="2148405265" sldId="279"/>
            <ac:picMk id="13" creationId="{CB638CA2-AF23-D444-9126-BD71D8269097}"/>
          </ac:picMkLst>
        </pc:picChg>
        <pc:picChg chg="del mod">
          <ac:chgData name="Thao Le" userId="c2d24242046cb3e5" providerId="LiveId" clId="{414A3FDD-622A-8C4A-9C66-040DA1A0EBF6}" dt="2020-11-02T09:32:59.433" v="66" actId="478"/>
          <ac:picMkLst>
            <pc:docMk/>
            <pc:sldMk cId="2148405265" sldId="279"/>
            <ac:picMk id="15" creationId="{F057CF50-1DCD-F740-A342-AB4C999E24E0}"/>
          </ac:picMkLst>
        </pc:picChg>
        <pc:picChg chg="del">
          <ac:chgData name="Thao Le" userId="c2d24242046cb3e5" providerId="LiveId" clId="{414A3FDD-622A-8C4A-9C66-040DA1A0EBF6}" dt="2020-11-02T09:33:01.858" v="67" actId="478"/>
          <ac:picMkLst>
            <pc:docMk/>
            <pc:sldMk cId="2148405265" sldId="279"/>
            <ac:picMk id="17" creationId="{4B627B0C-E037-DC4D-A085-AA6C63DC5C0A}"/>
          </ac:picMkLst>
        </pc:picChg>
        <pc:picChg chg="mod">
          <ac:chgData name="Thao Le" userId="c2d24242046cb3e5" providerId="LiveId" clId="{414A3FDD-622A-8C4A-9C66-040DA1A0EBF6}" dt="2020-11-02T10:39:32.886" v="390" actId="1038"/>
          <ac:picMkLst>
            <pc:docMk/>
            <pc:sldMk cId="2148405265" sldId="279"/>
            <ac:picMk id="29" creationId="{39FF9FB8-33D7-1943-A303-FA6AC50D1535}"/>
          </ac:picMkLst>
        </pc:picChg>
        <pc:picChg chg="mod">
          <ac:chgData name="Thao Le" userId="c2d24242046cb3e5" providerId="LiveId" clId="{414A3FDD-622A-8C4A-9C66-040DA1A0EBF6}" dt="2020-11-02T10:30:18.070" v="376" actId="1038"/>
          <ac:picMkLst>
            <pc:docMk/>
            <pc:sldMk cId="2148405265" sldId="279"/>
            <ac:picMk id="31" creationId="{77D7C61C-0F55-6649-861D-DA4BFF4836F8}"/>
          </ac:picMkLst>
        </pc:picChg>
        <pc:picChg chg="mod">
          <ac:chgData name="Thao Le" userId="c2d24242046cb3e5" providerId="LiveId" clId="{414A3FDD-622A-8C4A-9C66-040DA1A0EBF6}" dt="2020-11-02T09:39:40.523" v="106" actId="1076"/>
          <ac:picMkLst>
            <pc:docMk/>
            <pc:sldMk cId="2148405265" sldId="279"/>
            <ac:picMk id="37" creationId="{629A6ACD-E98E-0744-AB55-6F0716C1549F}"/>
          </ac:picMkLst>
        </pc:picChg>
        <pc:picChg chg="mod">
          <ac:chgData name="Thao Le" userId="c2d24242046cb3e5" providerId="LiveId" clId="{414A3FDD-622A-8C4A-9C66-040DA1A0EBF6}" dt="2020-11-02T10:40:54.863" v="430" actId="1076"/>
          <ac:picMkLst>
            <pc:docMk/>
            <pc:sldMk cId="2148405265" sldId="279"/>
            <ac:picMk id="41" creationId="{DD6C7BCB-B5EF-5C4D-9DA7-863B3EF808C6}"/>
          </ac:picMkLst>
        </pc:picChg>
        <pc:cxnChg chg="add del mod">
          <ac:chgData name="Thao Le" userId="c2d24242046cb3e5" providerId="LiveId" clId="{414A3FDD-622A-8C4A-9C66-040DA1A0EBF6}" dt="2020-11-02T10:42:11.441" v="441" actId="478"/>
          <ac:cxnSpMkLst>
            <pc:docMk/>
            <pc:sldMk cId="2148405265" sldId="279"/>
            <ac:cxnSpMk id="18" creationId="{E0488133-D3CC-7E45-A793-7283C72B004B}"/>
          </ac:cxnSpMkLst>
        </pc:cxnChg>
      </pc:sldChg>
      <pc:sldChg chg="addSp delSp modSp add mod ord">
        <pc:chgData name="Thao Le" userId="c2d24242046cb3e5" providerId="LiveId" clId="{414A3FDD-622A-8C4A-9C66-040DA1A0EBF6}" dt="2020-11-03T01:45:58.772" v="513" actId="13926"/>
        <pc:sldMkLst>
          <pc:docMk/>
          <pc:sldMk cId="4279046182" sldId="284"/>
        </pc:sldMkLst>
        <pc:spChg chg="del">
          <ac:chgData name="Thao Le" userId="c2d24242046cb3e5" providerId="LiveId" clId="{414A3FDD-622A-8C4A-9C66-040DA1A0EBF6}" dt="2020-11-02T08:12:05.454" v="3" actId="478"/>
          <ac:spMkLst>
            <pc:docMk/>
            <pc:sldMk cId="4279046182" sldId="284"/>
            <ac:spMk id="2" creationId="{FC0E229F-93CD-0C40-8569-1116C4725EAB}"/>
          </ac:spMkLst>
        </pc:spChg>
        <pc:spChg chg="del">
          <ac:chgData name="Thao Le" userId="c2d24242046cb3e5" providerId="LiveId" clId="{414A3FDD-622A-8C4A-9C66-040DA1A0EBF6}" dt="2020-11-02T08:12:02.883" v="2" actId="478"/>
          <ac:spMkLst>
            <pc:docMk/>
            <pc:sldMk cId="4279046182" sldId="284"/>
            <ac:spMk id="3" creationId="{B0739030-1EC0-9F46-8C83-DD91928C58FD}"/>
          </ac:spMkLst>
        </pc:spChg>
        <pc:spChg chg="add mod">
          <ac:chgData name="Thao Le" userId="c2d24242046cb3e5" providerId="LiveId" clId="{414A3FDD-622A-8C4A-9C66-040DA1A0EBF6}" dt="2020-11-02T08:11:59.706" v="1"/>
          <ac:spMkLst>
            <pc:docMk/>
            <pc:sldMk cId="4279046182" sldId="284"/>
            <ac:spMk id="4" creationId="{8D5EE70B-B911-A44F-A2DF-45CE5BA2C907}"/>
          </ac:spMkLst>
        </pc:spChg>
        <pc:spChg chg="add mod">
          <ac:chgData name="Thao Le" userId="c2d24242046cb3e5" providerId="LiveId" clId="{414A3FDD-622A-8C4A-9C66-040DA1A0EBF6}" dt="2020-11-03T01:45:58.772" v="513" actId="13926"/>
          <ac:spMkLst>
            <pc:docMk/>
            <pc:sldMk cId="4279046182" sldId="284"/>
            <ac:spMk id="5" creationId="{AE158953-26AA-1A49-8E0D-AA74D0262371}"/>
          </ac:spMkLst>
        </pc:spChg>
      </pc:sldChg>
      <pc:sldChg chg="addSp delSp modSp add mod">
        <pc:chgData name="Thao Le" userId="c2d24242046cb3e5" providerId="LiveId" clId="{414A3FDD-622A-8C4A-9C66-040DA1A0EBF6}" dt="2020-11-02T09:52:16.193" v="303" actId="20577"/>
        <pc:sldMkLst>
          <pc:docMk/>
          <pc:sldMk cId="1134934160" sldId="285"/>
        </pc:sldMkLst>
        <pc:spChg chg="del">
          <ac:chgData name="Thao Le" userId="c2d24242046cb3e5" providerId="LiveId" clId="{414A3FDD-622A-8C4A-9C66-040DA1A0EBF6}" dt="2020-11-02T09:31:45.350" v="52" actId="478"/>
          <ac:spMkLst>
            <pc:docMk/>
            <pc:sldMk cId="1134934160" sldId="285"/>
            <ac:spMk id="2" creationId="{8D19962E-D5A8-1743-89E8-DB51F7CFE86F}"/>
          </ac:spMkLst>
        </pc:spChg>
        <pc:spChg chg="del">
          <ac:chgData name="Thao Le" userId="c2d24242046cb3e5" providerId="LiveId" clId="{414A3FDD-622A-8C4A-9C66-040DA1A0EBF6}" dt="2020-11-02T09:31:47.639" v="53" actId="478"/>
          <ac:spMkLst>
            <pc:docMk/>
            <pc:sldMk cId="1134934160" sldId="285"/>
            <ac:spMk id="3" creationId="{B6372094-CB33-6646-937D-60F26A084869}"/>
          </ac:spMkLst>
        </pc:spChg>
        <pc:spChg chg="add mod">
          <ac:chgData name="Thao Le" userId="c2d24242046cb3e5" providerId="LiveId" clId="{414A3FDD-622A-8C4A-9C66-040DA1A0EBF6}" dt="2020-11-02T09:31:58.863" v="54"/>
          <ac:spMkLst>
            <pc:docMk/>
            <pc:sldMk cId="1134934160" sldId="285"/>
            <ac:spMk id="4" creationId="{D8D2642F-6A13-994F-9029-9C4C8B29F58B}"/>
          </ac:spMkLst>
        </pc:spChg>
        <pc:spChg chg="add mod">
          <ac:chgData name="Thao Le" userId="c2d24242046cb3e5" providerId="LiveId" clId="{414A3FDD-622A-8C4A-9C66-040DA1A0EBF6}" dt="2020-11-02T09:52:16.193" v="303" actId="20577"/>
          <ac:spMkLst>
            <pc:docMk/>
            <pc:sldMk cId="1134934160" sldId="285"/>
            <ac:spMk id="5" creationId="{4A2FAB72-02B5-734D-9A63-0743BF12117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0C7CC3-9AB7-4545-8AB3-BF83E9B1E2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452A83-EB4E-9A40-97D7-8125584484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E2113E-84C0-124A-B727-73E6845FF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05258F-1DD2-174C-8AE1-2EDC5CC18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A38272-0463-6C4B-9D63-28131194D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932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E7C3DA-6BA8-B444-A375-309584780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917D19-F20E-1444-AE3E-6F93440585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E8CEB7-A3DD-0841-B587-9D8C1FD9F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D1D44D-7752-6E4F-92FE-E5A3611CB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A719A5-7018-1B4C-BBA6-54BB14392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503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6D6EE0B-6337-4D4D-B250-FA88F2B907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FDE98-0EBD-6C43-9B65-0E0BC42046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985256-6E61-BE48-9919-EFE9B34B6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2AB494-84BE-6A40-BE18-5D98F53F9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E9C0E6-E5BA-344A-A195-5DD3EDC6CD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64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7A39A8-78E8-AA4E-A3BA-FD7944836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179E53-8257-E94B-B2BB-4E50696948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C28EF2-A2F5-9749-8B8C-C968A8D61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AE31C-3319-D941-83FF-513C605ED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7AC57D-ABEF-5445-971C-DE065B064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174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BCCAB0-2F31-A448-A7CD-33A521F65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A6BDC8-F1E6-1F44-AF7A-D8CCC49384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DFE59D-D5FD-D647-8135-937335637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8E6C38-1C08-9C4A-A4D4-5A7409F48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9B88FF-1AD5-7246-ABB4-F211F9A05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197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EFB58A-E1C0-A64E-96B6-88D02C5F69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C73526-4734-7546-AB7D-DD894CD376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0A280E-CC17-B04F-8AE7-551F3BB748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B6E55D-527C-BD47-B737-84D6711BE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9AC1F0-975D-984F-A770-9CD001381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D1409C-D0CF-4345-8304-87B0F8AF1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459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E40935-81E1-5B45-8D2B-A745DB0A0C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D7AC7C-DFD3-7345-851C-4DD3EDAC02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CF53E4-6E6E-ED49-B8B9-348F0AC8B4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2CF540-80A0-164B-A95B-EC11405747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771ACC-59B4-AD4E-A626-836A7E2C5F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CB5D88-0D2F-7048-8CE7-2B2B58BC4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F2EB067-1504-1F40-8DC8-D2F745F87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275F3E-75D4-124D-BDD0-7BE197D22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796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AFA775-30B3-D445-AE4B-3AA36A857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7A71805-61D5-404D-9AB8-E45864713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264BA6-8534-2B4E-B865-4B4533652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A98C25-4B10-1A4A-9728-6BEA4EA50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289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AC2ABF-3CDF-B843-82F6-FF7576830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1BEBAA-40FC-F44C-99D8-330F66CAE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56D42A-DF0C-C74D-93D2-2DE6EE66B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904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307EBA-3E2C-B841-9C91-D05A2E12F8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88B7CE-AF70-D24A-ADE8-AFF5C4E723A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516565-66F8-6344-AD0F-E5B75383B9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C9442C-6619-ED42-A50A-1FE7A9001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7E7616-B87E-274D-8DB1-50C82C950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0316A1-EDD6-FA4E-B715-5AECAF7B4F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263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6E7507-B22A-1D41-A480-18A6A977D4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F2DBF1A-04C6-134F-989C-321EFA983E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799C5C-6D08-E842-9EBD-94837872C9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60C41B-FA23-244D-A055-CE50119F7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BE57FC-FC2E-C941-A222-0C3785F54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627ECE-AC7A-4A48-B931-B22C2CF26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978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BEA863-24BB-C94C-BD74-8587AD107E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EA5216-8101-E044-A2F3-D637942677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D5294B-6AA1-AF42-A8D9-5F528586A9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8B98C1-D357-DA4F-8054-647D25978614}" type="datetimeFigureOut">
              <a:rPr lang="en-US" smtClean="0"/>
              <a:t>11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5F555D-6A64-2D4F-A481-2F0E825BC2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F4B69A-98C2-A743-A722-C5AA80F5C5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7B8D6-E072-1347-B215-56CA36BAD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439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"/><Relationship Id="rId3" Type="http://schemas.openxmlformats.org/officeDocument/2006/relationships/image" Target="../media/image4.tif"/><Relationship Id="rId7" Type="http://schemas.openxmlformats.org/officeDocument/2006/relationships/image" Target="../media/image8.tif"/><Relationship Id="rId12" Type="http://schemas.openxmlformats.org/officeDocument/2006/relationships/image" Target="../media/image13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"/><Relationship Id="rId11" Type="http://schemas.openxmlformats.org/officeDocument/2006/relationships/image" Target="../media/image12.tif"/><Relationship Id="rId5" Type="http://schemas.openxmlformats.org/officeDocument/2006/relationships/image" Target="../media/image6.emf"/><Relationship Id="rId10" Type="http://schemas.openxmlformats.org/officeDocument/2006/relationships/image" Target="../media/image11.tif"/><Relationship Id="rId4" Type="http://schemas.openxmlformats.org/officeDocument/2006/relationships/image" Target="../media/image5.tif"/><Relationship Id="rId9" Type="http://schemas.openxmlformats.org/officeDocument/2006/relationships/image" Target="../media/image10.ti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microsoft.com/office/2007/relationships/media" Target="../media/media4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6" Type="http://schemas.openxmlformats.org/officeDocument/2006/relationships/video" Target="../media/media2.mp4"/><Relationship Id="rId5" Type="http://schemas.microsoft.com/office/2007/relationships/media" Target="../media/media2.mp4"/><Relationship Id="rId10" Type="http://schemas.openxmlformats.org/officeDocument/2006/relationships/image" Target="../media/image2.png"/><Relationship Id="rId4" Type="http://schemas.openxmlformats.org/officeDocument/2006/relationships/video" Target="../media/media4.mp4"/><Relationship Id="rId9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"/><Relationship Id="rId3" Type="http://schemas.openxmlformats.org/officeDocument/2006/relationships/image" Target="../media/image17.tif"/><Relationship Id="rId7" Type="http://schemas.openxmlformats.org/officeDocument/2006/relationships/image" Target="../media/image21.tif"/><Relationship Id="rId12" Type="http://schemas.openxmlformats.org/officeDocument/2006/relationships/image" Target="../media/image26.tif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emf"/><Relationship Id="rId11" Type="http://schemas.openxmlformats.org/officeDocument/2006/relationships/image" Target="../media/image25.tif"/><Relationship Id="rId5" Type="http://schemas.openxmlformats.org/officeDocument/2006/relationships/image" Target="../media/image19.tif"/><Relationship Id="rId10" Type="http://schemas.openxmlformats.org/officeDocument/2006/relationships/image" Target="../media/image24.tif"/><Relationship Id="rId4" Type="http://schemas.openxmlformats.org/officeDocument/2006/relationships/image" Target="../media/image18.tif"/><Relationship Id="rId9" Type="http://schemas.openxmlformats.org/officeDocument/2006/relationships/image" Target="../media/image23.ti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microsoft.com/office/2007/relationships/media" Target="../media/media6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6" Type="http://schemas.openxmlformats.org/officeDocument/2006/relationships/video" Target="../media/media7.mp4"/><Relationship Id="rId5" Type="http://schemas.microsoft.com/office/2007/relationships/media" Target="../media/media7.mp4"/><Relationship Id="rId10" Type="http://schemas.openxmlformats.org/officeDocument/2006/relationships/image" Target="../media/image29.png"/><Relationship Id="rId4" Type="http://schemas.openxmlformats.org/officeDocument/2006/relationships/video" Target="../media/media6.mp4"/><Relationship Id="rId9" Type="http://schemas.openxmlformats.org/officeDocument/2006/relationships/image" Target="../media/image2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AA287B-C26B-C44C-842D-03A1B0D000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564924"/>
            <a:ext cx="9144000" cy="2178275"/>
          </a:xfrm>
        </p:spPr>
        <p:txBody>
          <a:bodyPr>
            <a:normAutofit/>
          </a:bodyPr>
          <a:lstStyle/>
          <a:p>
            <a:r>
              <a:rPr lang="en-US" sz="4000" dirty="0">
                <a:latin typeface="Arial" panose="020B0604020202020204" pitchFamily="34" charset="0"/>
                <a:cs typeface="Arial" panose="020B0604020202020204" pitchFamily="34" charset="0"/>
              </a:rPr>
              <a:t>Online Supplementary</a:t>
            </a:r>
            <a:br>
              <a:rPr lang="en-US" sz="4000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en-US" sz="4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Multiparametric Exercise Stress Cardiovascular Magnetic Resonance in the Diagnosis of Coronary Artery Disease: The EMPIRE Trial </a:t>
            </a:r>
          </a:p>
        </p:txBody>
      </p:sp>
    </p:spTree>
    <p:extLst>
      <p:ext uri="{BB962C8B-B14F-4D97-AF65-F5344CB8AC3E}">
        <p14:creationId xmlns:p14="http://schemas.microsoft.com/office/powerpoint/2010/main" val="1033001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59E65-2314-6147-99B0-1DEC1D2494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3650673" cy="903011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Trial Profile Flow Chart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A4D5DFE7-0C64-1C47-A800-12C3A9576A34}"/>
              </a:ext>
            </a:extLst>
          </p:cNvPr>
          <p:cNvGrpSpPr/>
          <p:nvPr/>
        </p:nvGrpSpPr>
        <p:grpSpPr>
          <a:xfrm>
            <a:off x="3233102" y="839471"/>
            <a:ext cx="5725794" cy="5179060"/>
            <a:chOff x="-10335" y="10277"/>
            <a:chExt cx="5725947" cy="5179673"/>
          </a:xfrm>
        </p:grpSpPr>
        <p:sp>
          <p:nvSpPr>
            <p:cNvPr id="5" name="TextBox 3">
              <a:extLst>
                <a:ext uri="{FF2B5EF4-FFF2-40B4-BE49-F238E27FC236}">
                  <a16:creationId xmlns:a16="http://schemas.microsoft.com/office/drawing/2014/main" id="{34CFF538-E1F0-3D4E-95E2-BB942084B43A}"/>
                </a:ext>
              </a:extLst>
            </p:cNvPr>
            <p:cNvSpPr txBox="1"/>
            <p:nvPr/>
          </p:nvSpPr>
          <p:spPr>
            <a:xfrm rot="16200000">
              <a:off x="659273" y="1561752"/>
              <a:ext cx="533400" cy="18726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576 patients assessed for eligibility</a:t>
              </a:r>
              <a:endParaRPr lang="en-SG" sz="120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" name="TextBox 4">
              <a:extLst>
                <a:ext uri="{FF2B5EF4-FFF2-40B4-BE49-F238E27FC236}">
                  <a16:creationId xmlns:a16="http://schemas.microsoft.com/office/drawing/2014/main" id="{94C8DE69-1359-A943-BDC1-20069AA9A54D}"/>
                </a:ext>
              </a:extLst>
            </p:cNvPr>
            <p:cNvSpPr txBox="1"/>
            <p:nvPr/>
          </p:nvSpPr>
          <p:spPr>
            <a:xfrm rot="16200000">
              <a:off x="2470287" y="3906425"/>
              <a:ext cx="358140" cy="9607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188 eligible</a:t>
              </a:r>
              <a:endParaRPr lang="en-SG" sz="120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" name="TextBox 5">
              <a:extLst>
                <a:ext uri="{FF2B5EF4-FFF2-40B4-BE49-F238E27FC236}">
                  <a16:creationId xmlns:a16="http://schemas.microsoft.com/office/drawing/2014/main" id="{55CF966F-2D51-7941-BCAE-2342F762723E}"/>
                </a:ext>
              </a:extLst>
            </p:cNvPr>
            <p:cNvSpPr txBox="1"/>
            <p:nvPr/>
          </p:nvSpPr>
          <p:spPr>
            <a:xfrm rot="16200000">
              <a:off x="2384164" y="699702"/>
              <a:ext cx="533400" cy="9607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388 excluded</a:t>
              </a:r>
              <a:endParaRPr lang="en-SG" sz="120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" name="TextBox 6">
              <a:extLst>
                <a:ext uri="{FF2B5EF4-FFF2-40B4-BE49-F238E27FC236}">
                  <a16:creationId xmlns:a16="http://schemas.microsoft.com/office/drawing/2014/main" id="{DB931AB8-1151-444F-B154-8E2C18264A30}"/>
                </a:ext>
              </a:extLst>
            </p:cNvPr>
            <p:cNvSpPr txBox="1"/>
            <p:nvPr/>
          </p:nvSpPr>
          <p:spPr>
            <a:xfrm rot="16200000">
              <a:off x="4541180" y="4015517"/>
              <a:ext cx="358140" cy="1990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US" sz="12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60 consented</a:t>
              </a:r>
              <a:endParaRPr lang="en-SG" sz="120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" name="TextBox 7">
              <a:extLst>
                <a:ext uri="{FF2B5EF4-FFF2-40B4-BE49-F238E27FC236}">
                  <a16:creationId xmlns:a16="http://schemas.microsoft.com/office/drawing/2014/main" id="{22EFE99A-2E06-8D4B-9CE6-9D17C2C58DAA}"/>
                </a:ext>
              </a:extLst>
            </p:cNvPr>
            <p:cNvSpPr txBox="1"/>
            <p:nvPr/>
          </p:nvSpPr>
          <p:spPr>
            <a:xfrm rot="16200000">
              <a:off x="4541178" y="2725591"/>
              <a:ext cx="358140" cy="1990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128 withheld consent</a:t>
              </a:r>
              <a:endParaRPr lang="en-SG" sz="120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8">
              <a:extLst>
                <a:ext uri="{FF2B5EF4-FFF2-40B4-BE49-F238E27FC236}">
                  <a16:creationId xmlns:a16="http://schemas.microsoft.com/office/drawing/2014/main" id="{1215EDBB-5BF5-F94C-914E-F7C67E9C01A3}"/>
                </a:ext>
              </a:extLst>
            </p:cNvPr>
            <p:cNvSpPr txBox="1"/>
            <p:nvPr/>
          </p:nvSpPr>
          <p:spPr>
            <a:xfrm rot="16200000">
              <a:off x="4448852" y="-718386"/>
              <a:ext cx="533400" cy="1990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178 with previous coronary artery interventions</a:t>
              </a:r>
              <a:endParaRPr lang="en-SG" sz="120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9">
              <a:extLst>
                <a:ext uri="{FF2B5EF4-FFF2-40B4-BE49-F238E27FC236}">
                  <a16:creationId xmlns:a16="http://schemas.microsoft.com/office/drawing/2014/main" id="{A0E4C278-5550-5342-AA44-A93F2DE37DEC}"/>
                </a:ext>
              </a:extLst>
            </p:cNvPr>
            <p:cNvSpPr txBox="1"/>
            <p:nvPr/>
          </p:nvSpPr>
          <p:spPr>
            <a:xfrm rot="16200000">
              <a:off x="4541181" y="184603"/>
              <a:ext cx="358140" cy="199009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31 with physical disabilities</a:t>
              </a:r>
              <a:endParaRPr lang="en-SG" sz="120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0">
              <a:extLst>
                <a:ext uri="{FF2B5EF4-FFF2-40B4-BE49-F238E27FC236}">
                  <a16:creationId xmlns:a16="http://schemas.microsoft.com/office/drawing/2014/main" id="{F78CA597-DD5C-B345-BB22-63F826138227}"/>
                </a:ext>
              </a:extLst>
            </p:cNvPr>
            <p:cNvSpPr txBox="1"/>
            <p:nvPr/>
          </p:nvSpPr>
          <p:spPr>
            <a:xfrm rot="16200000">
              <a:off x="4079541" y="1454962"/>
              <a:ext cx="1234440" cy="1990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US" sz="12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179 with acute coronary syndromes, contraindications to contrast CMR or inability to tolerate adenosine for FFR assessment</a:t>
              </a:r>
              <a:endParaRPr lang="en-SG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13" name="Elbow Connector 12">
              <a:extLst>
                <a:ext uri="{FF2B5EF4-FFF2-40B4-BE49-F238E27FC236}">
                  <a16:creationId xmlns:a16="http://schemas.microsoft.com/office/drawing/2014/main" id="{026E6B86-765E-D549-A248-46E615F980F3}"/>
                </a:ext>
              </a:extLst>
            </p:cNvPr>
            <p:cNvCxnSpPr>
              <a:cxnSpLocks/>
              <a:stCxn id="5" idx="1"/>
              <a:endCxn id="6" idx="0"/>
            </p:cNvCxnSpPr>
            <p:nvPr/>
          </p:nvCxnSpPr>
          <p:spPr>
            <a:xfrm rot="16200000" flipH="1">
              <a:off x="749677" y="2961668"/>
              <a:ext cx="1611719" cy="1238493"/>
            </a:xfrm>
            <a:prstGeom prst="bentConnector2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Elbow Connector 13">
              <a:extLst>
                <a:ext uri="{FF2B5EF4-FFF2-40B4-BE49-F238E27FC236}">
                  <a16:creationId xmlns:a16="http://schemas.microsoft.com/office/drawing/2014/main" id="{1B5766AD-9B03-894F-B0FF-7D5C79C28EFC}"/>
                </a:ext>
              </a:extLst>
            </p:cNvPr>
            <p:cNvCxnSpPr>
              <a:cxnSpLocks/>
              <a:stCxn id="5" idx="3"/>
              <a:endCxn id="7" idx="0"/>
            </p:cNvCxnSpPr>
            <p:nvPr/>
          </p:nvCxnSpPr>
          <p:spPr>
            <a:xfrm rot="5400000" flipH="1" flipV="1">
              <a:off x="1038122" y="1078190"/>
              <a:ext cx="1041037" cy="1244700"/>
            </a:xfrm>
            <a:prstGeom prst="bentConnector2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Elbow Connector 14">
              <a:extLst>
                <a:ext uri="{FF2B5EF4-FFF2-40B4-BE49-F238E27FC236}">
                  <a16:creationId xmlns:a16="http://schemas.microsoft.com/office/drawing/2014/main" id="{D2ED2E31-C7D4-AB46-8913-2184E045BB99}"/>
                </a:ext>
              </a:extLst>
            </p:cNvPr>
            <p:cNvCxnSpPr>
              <a:stCxn id="7" idx="3"/>
              <a:endCxn id="10" idx="0"/>
            </p:cNvCxnSpPr>
            <p:nvPr/>
          </p:nvCxnSpPr>
          <p:spPr>
            <a:xfrm rot="5400000" flipH="1" flipV="1">
              <a:off x="2882995" y="55307"/>
              <a:ext cx="626023" cy="1069409"/>
            </a:xfrm>
            <a:prstGeom prst="bentConnector2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Elbow Connector 15">
              <a:extLst>
                <a:ext uri="{FF2B5EF4-FFF2-40B4-BE49-F238E27FC236}">
                  <a16:creationId xmlns:a16="http://schemas.microsoft.com/office/drawing/2014/main" id="{9C65A958-2F92-7443-A93F-E3646C143286}"/>
                </a:ext>
              </a:extLst>
            </p:cNvPr>
            <p:cNvCxnSpPr>
              <a:stCxn id="7" idx="2"/>
              <a:endCxn id="11" idx="0"/>
            </p:cNvCxnSpPr>
            <p:nvPr/>
          </p:nvCxnSpPr>
          <p:spPr>
            <a:xfrm>
              <a:off x="3141613" y="1180020"/>
              <a:ext cx="589099" cy="1"/>
            </a:xfrm>
            <a:prstGeom prst="bentConnector3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Elbow Connector 16">
              <a:extLst>
                <a:ext uri="{FF2B5EF4-FFF2-40B4-BE49-F238E27FC236}">
                  <a16:creationId xmlns:a16="http://schemas.microsoft.com/office/drawing/2014/main" id="{8FC0B838-35CB-7E49-944B-696DC2AC1BD7}"/>
                </a:ext>
              </a:extLst>
            </p:cNvPr>
            <p:cNvCxnSpPr>
              <a:stCxn id="7" idx="1"/>
              <a:endCxn id="12" idx="0"/>
            </p:cNvCxnSpPr>
            <p:nvPr/>
          </p:nvCxnSpPr>
          <p:spPr>
            <a:xfrm rot="16200000" flipH="1">
              <a:off x="2699250" y="1419071"/>
              <a:ext cx="993510" cy="1069407"/>
            </a:xfrm>
            <a:prstGeom prst="bentConnector2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Elbow Connector 17">
              <a:extLst>
                <a:ext uri="{FF2B5EF4-FFF2-40B4-BE49-F238E27FC236}">
                  <a16:creationId xmlns:a16="http://schemas.microsoft.com/office/drawing/2014/main" id="{805CBF1C-612A-1E46-B41F-654BC06F7460}"/>
                </a:ext>
              </a:extLst>
            </p:cNvPr>
            <p:cNvCxnSpPr>
              <a:stCxn id="6" idx="3"/>
              <a:endCxn id="9" idx="0"/>
            </p:cNvCxnSpPr>
            <p:nvPr/>
          </p:nvCxnSpPr>
          <p:spPr>
            <a:xfrm rot="5400000" flipH="1" flipV="1">
              <a:off x="2952368" y="3423767"/>
              <a:ext cx="481071" cy="1075614"/>
            </a:xfrm>
            <a:prstGeom prst="bentConnector2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Elbow Connector 18">
              <a:extLst>
                <a:ext uri="{FF2B5EF4-FFF2-40B4-BE49-F238E27FC236}">
                  <a16:creationId xmlns:a16="http://schemas.microsoft.com/office/drawing/2014/main" id="{086EACD6-5DA6-5B4A-920E-3BC8EE450775}"/>
                </a:ext>
              </a:extLst>
            </p:cNvPr>
            <p:cNvCxnSpPr>
              <a:stCxn id="6" idx="1"/>
              <a:endCxn id="8" idx="0"/>
            </p:cNvCxnSpPr>
            <p:nvPr/>
          </p:nvCxnSpPr>
          <p:spPr>
            <a:xfrm rot="16200000" flipH="1">
              <a:off x="2973148" y="4253389"/>
              <a:ext cx="439512" cy="1075616"/>
            </a:xfrm>
            <a:prstGeom prst="bentConnector2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88332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73D741-2292-E740-91AE-4AAF33178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4090060" cy="941161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Motion Correction (MOCO)</a:t>
            </a:r>
          </a:p>
        </p:txBody>
      </p:sp>
      <p:pic>
        <p:nvPicPr>
          <p:cNvPr id="4" name="Positive Perfusion_Stress_No MOCO-105-slice3.mp4" descr="Positive Perfusion_Stress_No MOCO-105-slice3.mp4">
            <a:hlinkClick r:id="" action="ppaction://media"/>
            <a:extLst>
              <a:ext uri="{FF2B5EF4-FFF2-40B4-BE49-F238E27FC236}">
                <a16:creationId xmlns:a16="http://schemas.microsoft.com/office/drawing/2014/main" id="{B6788EB4-2676-8B49-BBFA-8AC399A2A89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12256" r="12354" b="2419"/>
          <a:stretch/>
        </p:blipFill>
        <p:spPr>
          <a:xfrm>
            <a:off x="838200" y="1734788"/>
            <a:ext cx="4434444" cy="4304820"/>
          </a:xfrm>
          <a:prstGeom prst="rect">
            <a:avLst/>
          </a:prstGeom>
        </p:spPr>
      </p:pic>
      <p:pic>
        <p:nvPicPr>
          <p:cNvPr id="5" name="Positive Perfusion_Stress_MOCO-109-slice3.mp4" descr="Positive Perfusion_Stress_MOCO-109-slice3.mp4">
            <a:hlinkClick r:id="" action="ppaction://media"/>
            <a:extLst>
              <a:ext uri="{FF2B5EF4-FFF2-40B4-BE49-F238E27FC236}">
                <a16:creationId xmlns:a16="http://schemas.microsoft.com/office/drawing/2014/main" id="{E81B1FFD-CB70-D84A-B19B-5CBBA7E9E2FD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/>
          <a:srcRect l="12402" r="12354" b="1445"/>
          <a:stretch/>
        </p:blipFill>
        <p:spPr>
          <a:xfrm>
            <a:off x="6096000" y="1709083"/>
            <a:ext cx="4408277" cy="433052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6FADB92-5E19-7246-A790-73CA66B3C080}"/>
              </a:ext>
            </a:extLst>
          </p:cNvPr>
          <p:cNvSpPr txBox="1"/>
          <p:nvPr/>
        </p:nvSpPr>
        <p:spPr>
          <a:xfrm>
            <a:off x="2161309" y="1306286"/>
            <a:ext cx="1971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17B57EC-E10D-7B47-AB25-4A7E6BEBA6D0}"/>
              </a:ext>
            </a:extLst>
          </p:cNvPr>
          <p:cNvSpPr txBox="1"/>
          <p:nvPr/>
        </p:nvSpPr>
        <p:spPr>
          <a:xfrm>
            <a:off x="7314486" y="1365456"/>
            <a:ext cx="1971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</a:p>
        </p:txBody>
      </p:sp>
    </p:spTree>
    <p:extLst>
      <p:ext uri="{BB962C8B-B14F-4D97-AF65-F5344CB8AC3E}">
        <p14:creationId xmlns:p14="http://schemas.microsoft.com/office/powerpoint/2010/main" val="26324361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939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4939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4939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0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ontent Placeholder 40" descr="A picture containing indoor, sitting, cat, laying&#10;&#10;Description automatically generated">
            <a:extLst>
              <a:ext uri="{FF2B5EF4-FFF2-40B4-BE49-F238E27FC236}">
                <a16:creationId xmlns:a16="http://schemas.microsoft.com/office/drawing/2014/main" id="{DD6C7BCB-B5EF-5C4D-9DA7-863B3EF808C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098011" y="1785451"/>
            <a:ext cx="1602829" cy="4808486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3765C8EE-0043-8042-9A06-516602AAA5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9991" y="205278"/>
            <a:ext cx="3260834" cy="769992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FR-positive Case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2DE68E7-4575-2744-8011-BE0CDC4124BE}"/>
              </a:ext>
            </a:extLst>
          </p:cNvPr>
          <p:cNvSpPr txBox="1"/>
          <p:nvPr/>
        </p:nvSpPr>
        <p:spPr>
          <a:xfrm>
            <a:off x="943302" y="1050600"/>
            <a:ext cx="9543177" cy="3751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6-year-old female with hypertension an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dyslipidaemi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29" name="Picture 28" descr="A close up&#10;&#10;Description automatically generated">
            <a:extLst>
              <a:ext uri="{FF2B5EF4-FFF2-40B4-BE49-F238E27FC236}">
                <a16:creationId xmlns:a16="http://schemas.microsoft.com/office/drawing/2014/main" id="{39FF9FB8-33D7-1943-A303-FA6AC50D15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4460" y="3367378"/>
            <a:ext cx="1616106" cy="1644631"/>
          </a:xfrm>
          <a:prstGeom prst="rect">
            <a:avLst/>
          </a:prstGeom>
        </p:spPr>
      </p:pic>
      <p:pic>
        <p:nvPicPr>
          <p:cNvPr id="31" name="Picture 30" descr="A picture containing indoor, cat, laying, lying&#10;&#10;Description automatically generated">
            <a:extLst>
              <a:ext uri="{FF2B5EF4-FFF2-40B4-BE49-F238E27FC236}">
                <a16:creationId xmlns:a16="http://schemas.microsoft.com/office/drawing/2014/main" id="{77D7C61C-0F55-6649-861D-DA4BFF4836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03402" y="3367378"/>
            <a:ext cx="1616107" cy="1616107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71CC86DA-EC22-2A45-81B3-6C6F4E11EC3D}"/>
              </a:ext>
            </a:extLst>
          </p:cNvPr>
          <p:cNvSpPr txBox="1"/>
          <p:nvPr/>
        </p:nvSpPr>
        <p:spPr>
          <a:xfrm rot="5400000">
            <a:off x="1686789" y="254845"/>
            <a:ext cx="461665" cy="277283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ional Wall Motion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629A6ACD-E98E-0744-AB55-6F0716C1549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379873" y="1762953"/>
            <a:ext cx="2597037" cy="2426740"/>
          </a:xfrm>
          <a:prstGeom prst="rect">
            <a:avLst/>
          </a:prstGeom>
        </p:spPr>
      </p:pic>
      <p:pic>
        <p:nvPicPr>
          <p:cNvPr id="4" name="Picture 3" descr="A picture containing wearing, looking, photo, cat&#10;&#10;Description automatically generated">
            <a:extLst>
              <a:ext uri="{FF2B5EF4-FFF2-40B4-BE49-F238E27FC236}">
                <a16:creationId xmlns:a16="http://schemas.microsoft.com/office/drawing/2014/main" id="{1C10E903-22BE-E248-9300-A9DDC616A5D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92905" y="5012009"/>
            <a:ext cx="1579216" cy="1579216"/>
          </a:xfrm>
          <a:prstGeom prst="rect">
            <a:avLst/>
          </a:prstGeom>
        </p:spPr>
      </p:pic>
      <p:pic>
        <p:nvPicPr>
          <p:cNvPr id="6" name="Picture 5" descr="A picture containing sitting, photo, close, laying&#10;&#10;Description automatically generated">
            <a:extLst>
              <a:ext uri="{FF2B5EF4-FFF2-40B4-BE49-F238E27FC236}">
                <a16:creationId xmlns:a16="http://schemas.microsoft.com/office/drawing/2014/main" id="{AE499061-7159-CD4E-AF38-84BC9E06F81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74460" y="1785451"/>
            <a:ext cx="1602829" cy="1602829"/>
          </a:xfrm>
          <a:prstGeom prst="rect">
            <a:avLst/>
          </a:prstGeom>
        </p:spPr>
      </p:pic>
      <p:pic>
        <p:nvPicPr>
          <p:cNvPr id="8" name="Picture 7" descr="A close up&#10;&#10;Description automatically generated">
            <a:extLst>
              <a:ext uri="{FF2B5EF4-FFF2-40B4-BE49-F238E27FC236}">
                <a16:creationId xmlns:a16="http://schemas.microsoft.com/office/drawing/2014/main" id="{6CF72788-B002-1F4A-AEF1-CF22CD707FA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03402" y="1786371"/>
            <a:ext cx="1581008" cy="1581008"/>
          </a:xfrm>
          <a:prstGeom prst="rect">
            <a:avLst/>
          </a:prstGeom>
        </p:spPr>
      </p:pic>
      <p:pic>
        <p:nvPicPr>
          <p:cNvPr id="10" name="Picture 9" descr="A close up of a tattoo&#10;&#10;Description automatically generated">
            <a:extLst>
              <a:ext uri="{FF2B5EF4-FFF2-40B4-BE49-F238E27FC236}">
                <a16:creationId xmlns:a16="http://schemas.microsoft.com/office/drawing/2014/main" id="{CCE3E03D-4458-5A49-9D2B-D010350C1DC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91814" y="4961902"/>
            <a:ext cx="1627695" cy="162769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B363008F-B2DC-274A-968D-DE5C4091BE6C}"/>
              </a:ext>
            </a:extLst>
          </p:cNvPr>
          <p:cNvSpPr txBox="1"/>
          <p:nvPr/>
        </p:nvSpPr>
        <p:spPr>
          <a:xfrm>
            <a:off x="3249102" y="1456598"/>
            <a:ext cx="1853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fusio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4BFBD6E-A141-BD46-8E77-33C02D8376F0}"/>
              </a:ext>
            </a:extLst>
          </p:cNvPr>
          <p:cNvSpPr txBox="1"/>
          <p:nvPr/>
        </p:nvSpPr>
        <p:spPr>
          <a:xfrm>
            <a:off x="5181124" y="1456598"/>
            <a:ext cx="2098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ess Perfusio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B4AB8FE-A26D-8540-B741-B3765F0A6300}"/>
              </a:ext>
            </a:extLst>
          </p:cNvPr>
          <p:cNvSpPr txBox="1"/>
          <p:nvPr/>
        </p:nvSpPr>
        <p:spPr>
          <a:xfrm>
            <a:off x="7805575" y="1468736"/>
            <a:ext cx="8673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GE</a:t>
            </a:r>
          </a:p>
        </p:txBody>
      </p:sp>
      <p:pic>
        <p:nvPicPr>
          <p:cNvPr id="5" name="Picture 4" descr="A picture containing indoor, dog, mouth, hat&#10;&#10;Description automatically generated">
            <a:extLst>
              <a:ext uri="{FF2B5EF4-FFF2-40B4-BE49-F238E27FC236}">
                <a16:creationId xmlns:a16="http://schemas.microsoft.com/office/drawing/2014/main" id="{82A47415-6F95-874F-BACA-7A45197A367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411303" y="4985521"/>
            <a:ext cx="1590428" cy="1590428"/>
          </a:xfrm>
          <a:prstGeom prst="rect">
            <a:avLst/>
          </a:prstGeom>
        </p:spPr>
      </p:pic>
      <p:pic>
        <p:nvPicPr>
          <p:cNvPr id="9" name="Picture 8" descr="A picture containing cat, looking, sitting, close&#10;&#10;Description automatically generated">
            <a:extLst>
              <a:ext uri="{FF2B5EF4-FFF2-40B4-BE49-F238E27FC236}">
                <a16:creationId xmlns:a16="http://schemas.microsoft.com/office/drawing/2014/main" id="{7A4DB7AE-CD50-314D-B4F0-8E20ED4131E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411303" y="3415352"/>
            <a:ext cx="1590427" cy="1590427"/>
          </a:xfrm>
          <a:prstGeom prst="rect">
            <a:avLst/>
          </a:prstGeom>
        </p:spPr>
      </p:pic>
      <p:pic>
        <p:nvPicPr>
          <p:cNvPr id="13" name="Picture 12" descr="A picture containing motorcycle, sitting, cat, close&#10;&#10;Description automatically generated">
            <a:extLst>
              <a:ext uri="{FF2B5EF4-FFF2-40B4-BE49-F238E27FC236}">
                <a16:creationId xmlns:a16="http://schemas.microsoft.com/office/drawing/2014/main" id="{CB638CA2-AF23-D444-9126-BD71D826909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411303" y="1794299"/>
            <a:ext cx="1590427" cy="1633583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CD35B20B-FF5C-9547-8321-67099B6963A9}"/>
              </a:ext>
            </a:extLst>
          </p:cNvPr>
          <p:cNvSpPr txBox="1"/>
          <p:nvPr/>
        </p:nvSpPr>
        <p:spPr>
          <a:xfrm>
            <a:off x="9517118" y="1482384"/>
            <a:ext cx="217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ercise Capacity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1CBF69C-7CB2-A14C-9074-A6CE60B367BF}"/>
              </a:ext>
            </a:extLst>
          </p:cNvPr>
          <p:cNvSpPr txBox="1"/>
          <p:nvPr/>
        </p:nvSpPr>
        <p:spPr>
          <a:xfrm rot="16200000">
            <a:off x="2834302" y="2338156"/>
            <a:ext cx="82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a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059942E-B2A2-494D-88A9-AA69ED2FA755}"/>
              </a:ext>
            </a:extLst>
          </p:cNvPr>
          <p:cNvSpPr txBox="1"/>
          <p:nvPr/>
        </p:nvSpPr>
        <p:spPr>
          <a:xfrm rot="16200000">
            <a:off x="2834302" y="3993222"/>
            <a:ext cx="82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1B07121-CEF8-AB4A-B04B-8A061432576C}"/>
              </a:ext>
            </a:extLst>
          </p:cNvPr>
          <p:cNvSpPr txBox="1"/>
          <p:nvPr/>
        </p:nvSpPr>
        <p:spPr>
          <a:xfrm rot="16200000">
            <a:off x="2707448" y="5605416"/>
            <a:ext cx="1080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ica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71C3E19-2C13-1B46-AEDD-A1748BF49205}"/>
              </a:ext>
            </a:extLst>
          </p:cNvPr>
          <p:cNvSpPr txBox="1"/>
          <p:nvPr/>
        </p:nvSpPr>
        <p:spPr>
          <a:xfrm rot="16200000">
            <a:off x="95084" y="2448307"/>
            <a:ext cx="1589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 diastol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C392FE7-8AE9-804A-92A0-9B8781A6BAE9}"/>
              </a:ext>
            </a:extLst>
          </p:cNvPr>
          <p:cNvSpPr txBox="1"/>
          <p:nvPr/>
        </p:nvSpPr>
        <p:spPr>
          <a:xfrm rot="16200000">
            <a:off x="96557" y="5673149"/>
            <a:ext cx="1589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 systole</a:t>
            </a:r>
          </a:p>
        </p:txBody>
      </p:sp>
      <p:sp>
        <p:nvSpPr>
          <p:cNvPr id="19" name="Down Arrow 18">
            <a:extLst>
              <a:ext uri="{FF2B5EF4-FFF2-40B4-BE49-F238E27FC236}">
                <a16:creationId xmlns:a16="http://schemas.microsoft.com/office/drawing/2014/main" id="{D93AA976-CDE9-4744-9DCE-A0897D2FE756}"/>
              </a:ext>
            </a:extLst>
          </p:cNvPr>
          <p:cNvSpPr/>
          <p:nvPr/>
        </p:nvSpPr>
        <p:spPr>
          <a:xfrm>
            <a:off x="889989" y="3427880"/>
            <a:ext cx="112771" cy="1573622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4052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BAE0B5D2-60DC-604D-BEB2-51D51F0F7D46}"/>
              </a:ext>
            </a:extLst>
          </p:cNvPr>
          <p:cNvSpPr txBox="1"/>
          <p:nvPr/>
        </p:nvSpPr>
        <p:spPr>
          <a:xfrm>
            <a:off x="634124" y="1670419"/>
            <a:ext cx="34038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al-time Cine at Peak Exercis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34E3BB2-1C3E-4E4B-A617-223C708B40CB}"/>
              </a:ext>
            </a:extLst>
          </p:cNvPr>
          <p:cNvSpPr txBox="1"/>
          <p:nvPr/>
        </p:nvSpPr>
        <p:spPr>
          <a:xfrm>
            <a:off x="5126420" y="1670419"/>
            <a:ext cx="193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st Perfusio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82FAA4C-2830-0146-951E-450D2A580776}"/>
              </a:ext>
            </a:extLst>
          </p:cNvPr>
          <p:cNvSpPr txBox="1"/>
          <p:nvPr/>
        </p:nvSpPr>
        <p:spPr>
          <a:xfrm>
            <a:off x="8829502" y="1670419"/>
            <a:ext cx="27283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ercise Stress Perfusion</a:t>
            </a:r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5D5CE7FB-35EE-B042-B386-1E137E9208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3199778" cy="769992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FR-positive Case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2" name="Positive rt_SAX_cine_p4_FOV300_25W_3MIN-95-slice7.mp4" descr="Positive rt_SAX_cine_p4_FOV300_25W_3MIN-95-slice7.mp4">
            <a:hlinkClick r:id="" action="ppaction://media"/>
            <a:extLst>
              <a:ext uri="{FF2B5EF4-FFF2-40B4-BE49-F238E27FC236}">
                <a16:creationId xmlns:a16="http://schemas.microsoft.com/office/drawing/2014/main" id="{6953D09A-E7B2-C843-B720-84E36BB7A641}"/>
              </a:ext>
            </a:extLst>
          </p:cNvPr>
          <p:cNvPicPr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8"/>
          <a:srcRect l="13406" t="10043" r="12500" b="5647"/>
          <a:stretch/>
        </p:blipFill>
        <p:spPr>
          <a:xfrm>
            <a:off x="367862" y="2083692"/>
            <a:ext cx="3670115" cy="3450021"/>
          </a:xfrm>
          <a:prstGeom prst="rect">
            <a:avLst/>
          </a:prstGeom>
        </p:spPr>
      </p:pic>
      <p:pic>
        <p:nvPicPr>
          <p:cNvPr id="3" name="Positive Perfusion_REST_MOCO-147-slice3.mp4" descr="Positive Perfusion_REST_MOCO-147-slice3.mp4">
            <a:hlinkClick r:id="" action="ppaction://media"/>
            <a:extLst>
              <a:ext uri="{FF2B5EF4-FFF2-40B4-BE49-F238E27FC236}">
                <a16:creationId xmlns:a16="http://schemas.microsoft.com/office/drawing/2014/main" id="{E1E77125-1FFA-A84B-90EA-FDCF75018A4E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>
            <a:lum contrast="2000"/>
          </a:blip>
          <a:srcRect l="18448" t="260" r="12306" b="15214"/>
          <a:stretch/>
        </p:blipFill>
        <p:spPr>
          <a:xfrm>
            <a:off x="4306781" y="2083692"/>
            <a:ext cx="3768446" cy="3450021"/>
          </a:xfrm>
          <a:prstGeom prst="rect">
            <a:avLst/>
          </a:prstGeom>
        </p:spPr>
      </p:pic>
      <p:pic>
        <p:nvPicPr>
          <p:cNvPr id="4" name="Positive Perfusion_Stress_MOCO-109-slice3.mp4" descr="Positive Perfusion_Stress_MOCO-109-slice3.mp4">
            <a:hlinkClick r:id="" action="ppaction://media"/>
            <a:extLst>
              <a:ext uri="{FF2B5EF4-FFF2-40B4-BE49-F238E27FC236}">
                <a16:creationId xmlns:a16="http://schemas.microsoft.com/office/drawing/2014/main" id="{E557D0D4-D2B0-7D46-A8B8-E240E1E8C5C3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0">
            <a:lum bright="6000" contrast="19000"/>
          </a:blip>
          <a:srcRect l="19806" r="12695" b="15474"/>
          <a:stretch/>
        </p:blipFill>
        <p:spPr>
          <a:xfrm>
            <a:off x="8295457" y="2083691"/>
            <a:ext cx="3673442" cy="34500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04455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93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2937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4939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7876"/>
                            </p:stCondLst>
                            <p:childTnLst>
                              <p:par>
                                <p:cTn id="1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4939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25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D8D2642F-6A13-994F-9029-9C4C8B29F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43302" y="410192"/>
            <a:ext cx="3260834" cy="769992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FR-positive Case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A2FAB72-02B5-734D-9A63-0743BF121174}"/>
              </a:ext>
            </a:extLst>
          </p:cNvPr>
          <p:cNvSpPr txBox="1"/>
          <p:nvPr/>
        </p:nvSpPr>
        <p:spPr>
          <a:xfrm>
            <a:off x="844891" y="1348518"/>
            <a:ext cx="1063287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xercise Stress CMR: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ducible RWMA at mid anteroseptal, mid anterior and all apical segments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erfusion defects at mid anteroseptal, mid anterior and all apical segments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o infarction on LGE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ercise response: increase in cardiac index from 3.0 L/min/m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at baseline to 4.5 L/min/m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at peak exercise (8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percentile specific for age and sex)</a:t>
            </a:r>
          </a:p>
          <a:p>
            <a:pPr algn="just"/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nvasive Coronary Angiography:</a:t>
            </a:r>
            <a:endParaRPr lang="en-US" sz="16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FR</a:t>
            </a:r>
            <a:r>
              <a:rPr lang="en-US" sz="1600" b="1" baseline="-250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LAD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0.5 (90% obstruction by visual assessment)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49341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close up of a person&#10;&#10;Description automatically generated">
            <a:extLst>
              <a:ext uri="{FF2B5EF4-FFF2-40B4-BE49-F238E27FC236}">
                <a16:creationId xmlns:a16="http://schemas.microsoft.com/office/drawing/2014/main" id="{63957CED-EB6B-954C-87DF-8687305CE1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61766" y="3413248"/>
            <a:ext cx="1577721" cy="1615362"/>
          </a:xfrm>
          <a:prstGeom prst="rect">
            <a:avLst/>
          </a:prstGeom>
        </p:spPr>
      </p:pic>
      <p:pic>
        <p:nvPicPr>
          <p:cNvPr id="6" name="Content Placeholder 5" descr="A picture containing sitting, table, cake, holding&#10;&#10;Description automatically generated">
            <a:extLst>
              <a:ext uri="{FF2B5EF4-FFF2-40B4-BE49-F238E27FC236}">
                <a16:creationId xmlns:a16="http://schemas.microsoft.com/office/drawing/2014/main" id="{C809D023-B21A-D74B-8873-FEE5507BA74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945254" y="1792190"/>
            <a:ext cx="1615361" cy="4823648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3765C8EE-0043-8042-9A06-516602AAA5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30198" y="272451"/>
            <a:ext cx="3260834" cy="769992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FR-normal Case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2DE68E7-4575-2744-8011-BE0CDC4124BE}"/>
              </a:ext>
            </a:extLst>
          </p:cNvPr>
          <p:cNvSpPr txBox="1"/>
          <p:nvPr/>
        </p:nvSpPr>
        <p:spPr>
          <a:xfrm>
            <a:off x="943302" y="998190"/>
            <a:ext cx="9543177" cy="3751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59-year-old female with diabetes, hypertension an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dyslipidaemi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18" name="Picture 17" descr="A picture containing photo, sitting, looking, standing&#10;&#10;Description automatically generated">
            <a:extLst>
              <a:ext uri="{FF2B5EF4-FFF2-40B4-BE49-F238E27FC236}">
                <a16:creationId xmlns:a16="http://schemas.microsoft.com/office/drawing/2014/main" id="{6460C849-BE8E-C040-99F6-46AF9ADFA2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7188" y="3404504"/>
            <a:ext cx="1615362" cy="1615362"/>
          </a:xfrm>
          <a:prstGeom prst="rect">
            <a:avLst/>
          </a:prstGeom>
        </p:spPr>
      </p:pic>
      <p:pic>
        <p:nvPicPr>
          <p:cNvPr id="20" name="Picture 19" descr="A close up of a dog&#10;&#10;Description automatically generated">
            <a:extLst>
              <a:ext uri="{FF2B5EF4-FFF2-40B4-BE49-F238E27FC236}">
                <a16:creationId xmlns:a16="http://schemas.microsoft.com/office/drawing/2014/main" id="{4198D839-8E9C-3540-B986-D6B730C48A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53617" y="3413248"/>
            <a:ext cx="1615362" cy="161536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7F3DC44-A9A1-0F4C-913D-0EA15DD666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147988" y="1739312"/>
            <a:ext cx="2609704" cy="2438576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B363008F-B2DC-274A-968D-DE5C4091BE6C}"/>
              </a:ext>
            </a:extLst>
          </p:cNvPr>
          <p:cNvSpPr txBox="1"/>
          <p:nvPr/>
        </p:nvSpPr>
        <p:spPr>
          <a:xfrm>
            <a:off x="3154823" y="1422858"/>
            <a:ext cx="1853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 Perfusio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B4AB8FE-A26D-8540-B741-B3765F0A6300}"/>
              </a:ext>
            </a:extLst>
          </p:cNvPr>
          <p:cNvSpPr txBox="1"/>
          <p:nvPr/>
        </p:nvSpPr>
        <p:spPr>
          <a:xfrm>
            <a:off x="7531399" y="1429624"/>
            <a:ext cx="10302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G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13C23B8-C20B-EB40-928D-5B271303DDE3}"/>
              </a:ext>
            </a:extLst>
          </p:cNvPr>
          <p:cNvSpPr txBox="1"/>
          <p:nvPr/>
        </p:nvSpPr>
        <p:spPr>
          <a:xfrm>
            <a:off x="8703647" y="3821100"/>
            <a:ext cx="14694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FFR = 0.8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08BEEAB-9909-F64A-9AF9-9A166514EA92}"/>
              </a:ext>
            </a:extLst>
          </p:cNvPr>
          <p:cNvSpPr txBox="1"/>
          <p:nvPr/>
        </p:nvSpPr>
        <p:spPr>
          <a:xfrm rot="5400000">
            <a:off x="1547479" y="206670"/>
            <a:ext cx="461665" cy="277283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ional Wall Motion</a:t>
            </a:r>
          </a:p>
        </p:txBody>
      </p:sp>
      <p:pic>
        <p:nvPicPr>
          <p:cNvPr id="7" name="Picture 6" descr="A picture containing sitting, photo, looking, teddy&#10;&#10;Description automatically generated">
            <a:extLst>
              <a:ext uri="{FF2B5EF4-FFF2-40B4-BE49-F238E27FC236}">
                <a16:creationId xmlns:a16="http://schemas.microsoft.com/office/drawing/2014/main" id="{9347A85D-F746-D34D-97F4-A45D53516F1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48630" y="1799466"/>
            <a:ext cx="1613782" cy="1613782"/>
          </a:xfrm>
          <a:prstGeom prst="rect">
            <a:avLst/>
          </a:prstGeom>
        </p:spPr>
      </p:pic>
      <p:pic>
        <p:nvPicPr>
          <p:cNvPr id="10" name="Picture 9" descr="A picture containing cat, looking, standing, close&#10;&#10;Description automatically generated">
            <a:extLst>
              <a:ext uri="{FF2B5EF4-FFF2-40B4-BE49-F238E27FC236}">
                <a16:creationId xmlns:a16="http://schemas.microsoft.com/office/drawing/2014/main" id="{1792008F-EE32-F143-8B41-9471FFDBCF7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80792" y="5027030"/>
            <a:ext cx="1583803" cy="1583803"/>
          </a:xfrm>
          <a:prstGeom prst="rect">
            <a:avLst/>
          </a:prstGeom>
        </p:spPr>
      </p:pic>
      <p:pic>
        <p:nvPicPr>
          <p:cNvPr id="12" name="Picture 11" descr="A picture containing teddy, bear, stuffed, small&#10;&#10;Description automatically generated">
            <a:extLst>
              <a:ext uri="{FF2B5EF4-FFF2-40B4-BE49-F238E27FC236}">
                <a16:creationId xmlns:a16="http://schemas.microsoft.com/office/drawing/2014/main" id="{43DFA92B-783E-D941-9BCE-89A9F1FEBFA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69124" y="1793014"/>
            <a:ext cx="1611490" cy="1611490"/>
          </a:xfrm>
          <a:prstGeom prst="rect">
            <a:avLst/>
          </a:prstGeom>
        </p:spPr>
      </p:pic>
      <p:pic>
        <p:nvPicPr>
          <p:cNvPr id="15" name="Picture 14" descr="A picture containing looking, wearing, cat, hat&#10;&#10;Description automatically generated">
            <a:extLst>
              <a:ext uri="{FF2B5EF4-FFF2-40B4-BE49-F238E27FC236}">
                <a16:creationId xmlns:a16="http://schemas.microsoft.com/office/drawing/2014/main" id="{0E2AF198-D4E3-464F-B158-C5DA7F69516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275654" y="5003955"/>
            <a:ext cx="1611883" cy="1611883"/>
          </a:xfrm>
          <a:prstGeom prst="rect">
            <a:avLst/>
          </a:prstGeom>
        </p:spPr>
      </p:pic>
      <p:pic>
        <p:nvPicPr>
          <p:cNvPr id="26" name="Picture 25" descr="A close up of a persons face&#10;&#10;Description automatically generated">
            <a:extLst>
              <a:ext uri="{FF2B5EF4-FFF2-40B4-BE49-F238E27FC236}">
                <a16:creationId xmlns:a16="http://schemas.microsoft.com/office/drawing/2014/main" id="{AD35F45E-74EF-0A4F-A636-86CE773B4F3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274196" y="5034214"/>
            <a:ext cx="1565291" cy="1576620"/>
          </a:xfrm>
          <a:prstGeom prst="rect">
            <a:avLst/>
          </a:prstGeom>
        </p:spPr>
      </p:pic>
      <p:pic>
        <p:nvPicPr>
          <p:cNvPr id="32" name="Picture 31" descr="A picture containing car, sitting, close, plate&#10;&#10;Description automatically generated">
            <a:extLst>
              <a:ext uri="{FF2B5EF4-FFF2-40B4-BE49-F238E27FC236}">
                <a16:creationId xmlns:a16="http://schemas.microsoft.com/office/drawing/2014/main" id="{7D8881DD-4AC4-1748-9FC2-41573584AA2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276755" y="1801758"/>
            <a:ext cx="1583804" cy="161149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A4BFBD6E-A141-BD46-8E77-33C02D8376F0}"/>
              </a:ext>
            </a:extLst>
          </p:cNvPr>
          <p:cNvSpPr txBox="1"/>
          <p:nvPr/>
        </p:nvSpPr>
        <p:spPr>
          <a:xfrm>
            <a:off x="5021763" y="1430134"/>
            <a:ext cx="21018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ess Perfusio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F7F9DE1-419A-E947-995B-5701D8E3DF55}"/>
              </a:ext>
            </a:extLst>
          </p:cNvPr>
          <p:cNvSpPr txBox="1"/>
          <p:nvPr/>
        </p:nvSpPr>
        <p:spPr>
          <a:xfrm>
            <a:off x="9398529" y="1429624"/>
            <a:ext cx="217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ercise Capacity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3237B17-D2A5-014C-A15D-D680B10C46EA}"/>
              </a:ext>
            </a:extLst>
          </p:cNvPr>
          <p:cNvSpPr txBox="1"/>
          <p:nvPr/>
        </p:nvSpPr>
        <p:spPr>
          <a:xfrm rot="16200000">
            <a:off x="2711470" y="2338156"/>
            <a:ext cx="82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a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925F54F-0D4D-624B-943B-24B2C0E0C83D}"/>
              </a:ext>
            </a:extLst>
          </p:cNvPr>
          <p:cNvSpPr txBox="1"/>
          <p:nvPr/>
        </p:nvSpPr>
        <p:spPr>
          <a:xfrm rot="16200000">
            <a:off x="2711470" y="3993222"/>
            <a:ext cx="82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95E0B01-48DC-4944-97FC-40C6BF4D9029}"/>
              </a:ext>
            </a:extLst>
          </p:cNvPr>
          <p:cNvSpPr txBox="1"/>
          <p:nvPr/>
        </p:nvSpPr>
        <p:spPr>
          <a:xfrm rot="16200000">
            <a:off x="2584616" y="5605416"/>
            <a:ext cx="1080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ica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E9CFE46-CE62-784D-AC70-BBC72D371888}"/>
              </a:ext>
            </a:extLst>
          </p:cNvPr>
          <p:cNvSpPr txBox="1"/>
          <p:nvPr/>
        </p:nvSpPr>
        <p:spPr>
          <a:xfrm rot="16200000">
            <a:off x="-27748" y="2448307"/>
            <a:ext cx="1589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 diastol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9FBF3AD-43F4-4443-93F5-FC86BE112550}"/>
              </a:ext>
            </a:extLst>
          </p:cNvPr>
          <p:cNvSpPr txBox="1"/>
          <p:nvPr/>
        </p:nvSpPr>
        <p:spPr>
          <a:xfrm rot="16200000">
            <a:off x="-26275" y="5673149"/>
            <a:ext cx="1589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 systole</a:t>
            </a:r>
          </a:p>
        </p:txBody>
      </p:sp>
      <p:sp>
        <p:nvSpPr>
          <p:cNvPr id="36" name="Down Arrow 35">
            <a:extLst>
              <a:ext uri="{FF2B5EF4-FFF2-40B4-BE49-F238E27FC236}">
                <a16:creationId xmlns:a16="http://schemas.microsoft.com/office/drawing/2014/main" id="{F4612B5C-79A4-F44C-B961-2075D7064937}"/>
              </a:ext>
            </a:extLst>
          </p:cNvPr>
          <p:cNvSpPr/>
          <p:nvPr/>
        </p:nvSpPr>
        <p:spPr>
          <a:xfrm>
            <a:off x="767157" y="3427880"/>
            <a:ext cx="112771" cy="1573622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6721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Normal Perfusion_REST_MOCO-slice2.mp4" descr="Normal Perfusion_REST_MOCO-slice2.mp4">
            <a:hlinkClick r:id="" action="ppaction://media"/>
            <a:extLst>
              <a:ext uri="{FF2B5EF4-FFF2-40B4-BE49-F238E27FC236}">
                <a16:creationId xmlns:a16="http://schemas.microsoft.com/office/drawing/2014/main" id="{BC49744F-0A21-364E-9515-90C11EB5D04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8"/>
          <a:srcRect l="12980" r="13024"/>
          <a:stretch/>
        </p:blipFill>
        <p:spPr>
          <a:xfrm>
            <a:off x="4394073" y="2083693"/>
            <a:ext cx="3403854" cy="3450021"/>
          </a:xfrm>
          <a:prstGeom prst="rect">
            <a:avLst/>
          </a:prstGeom>
        </p:spPr>
      </p:pic>
      <p:pic>
        <p:nvPicPr>
          <p:cNvPr id="12" name="Normal Perfusion_Stress_MOCO-121-slice2.mp4" descr="Normal Perfusion_Stress_MOCO-121-slice2.mp4">
            <a:hlinkClick r:id="" action="ppaction://media"/>
            <a:extLst>
              <a:ext uri="{FF2B5EF4-FFF2-40B4-BE49-F238E27FC236}">
                <a16:creationId xmlns:a16="http://schemas.microsoft.com/office/drawing/2014/main" id="{EDF077B3-93B1-1842-A7EB-8D36D9184343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/>
          <a:srcRect l="6664" r="7997"/>
          <a:stretch/>
        </p:blipFill>
        <p:spPr>
          <a:xfrm>
            <a:off x="8154022" y="2083693"/>
            <a:ext cx="3670116" cy="3450021"/>
          </a:xfrm>
          <a:prstGeom prst="rect">
            <a:avLst/>
          </a:prstGeom>
        </p:spPr>
      </p:pic>
      <p:pic>
        <p:nvPicPr>
          <p:cNvPr id="14" name="Normal rt_SAX_cine_p4_FOV300_50W_2MIN-111-slice6.mp4" descr="Normal rt_SAX_cine_p4_FOV300_50W_2MIN-111-slice6.mp4">
            <a:hlinkClick r:id="" action="ppaction://media"/>
            <a:extLst>
              <a:ext uri="{FF2B5EF4-FFF2-40B4-BE49-F238E27FC236}">
                <a16:creationId xmlns:a16="http://schemas.microsoft.com/office/drawing/2014/main" id="{91EF0CC7-28CE-9249-8025-B235EF5C585E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0"/>
          <a:srcRect l="35754" t="13146" r="11810" b="15991"/>
          <a:stretch/>
        </p:blipFill>
        <p:spPr>
          <a:xfrm>
            <a:off x="634124" y="2083693"/>
            <a:ext cx="3403854" cy="345002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BAE0B5D2-60DC-604D-BEB2-51D51F0F7D46}"/>
              </a:ext>
            </a:extLst>
          </p:cNvPr>
          <p:cNvSpPr txBox="1"/>
          <p:nvPr/>
        </p:nvSpPr>
        <p:spPr>
          <a:xfrm>
            <a:off x="634124" y="1670419"/>
            <a:ext cx="34038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al-time Cine at Peak Exercis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34E3BB2-1C3E-4E4B-A617-223C708B40CB}"/>
              </a:ext>
            </a:extLst>
          </p:cNvPr>
          <p:cNvSpPr txBox="1"/>
          <p:nvPr/>
        </p:nvSpPr>
        <p:spPr>
          <a:xfrm>
            <a:off x="5126420" y="1670419"/>
            <a:ext cx="193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st Perfusio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82FAA4C-2830-0146-951E-450D2A580776}"/>
              </a:ext>
            </a:extLst>
          </p:cNvPr>
          <p:cNvSpPr txBox="1"/>
          <p:nvPr/>
        </p:nvSpPr>
        <p:spPr>
          <a:xfrm>
            <a:off x="8829502" y="1670419"/>
            <a:ext cx="27283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ercise Stress Perfusion</a:t>
            </a:r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5D5CE7FB-35EE-B042-B386-1E137E9208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3199778" cy="769992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FR-normal Case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3570096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02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1202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4939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6141"/>
                            </p:stCondLst>
                            <p:childTnLst>
                              <p:par>
                                <p:cTn id="1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4939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25" repeatCount="indefinite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8D5EE70B-B911-A44F-A2DF-45CE5BA2C907}"/>
              </a:ext>
            </a:extLst>
          </p:cNvPr>
          <p:cNvSpPr txBox="1">
            <a:spLocks/>
          </p:cNvSpPr>
          <p:nvPr/>
        </p:nvSpPr>
        <p:spPr>
          <a:xfrm>
            <a:off x="943302" y="410192"/>
            <a:ext cx="3260834" cy="7699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b="1">
                <a:latin typeface="Arial" panose="020B0604020202020204" pitchFamily="34" charset="0"/>
                <a:cs typeface="Arial" panose="020B0604020202020204" pitchFamily="34" charset="0"/>
              </a:rPr>
              <a:t>FFR-normal Case</a:t>
            </a:r>
            <a:r>
              <a:rPr lang="en-US" sz="24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E158953-26AA-1A49-8E0D-AA74D0262371}"/>
              </a:ext>
            </a:extLst>
          </p:cNvPr>
          <p:cNvSpPr txBox="1"/>
          <p:nvPr/>
        </p:nvSpPr>
        <p:spPr>
          <a:xfrm>
            <a:off x="943302" y="1548149"/>
            <a:ext cx="1016919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xercise Stress CMR: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o inducible RWMA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o perfusion defects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o infarction on LGE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ercise response: increase in cardiac index from 2.1 L/min/m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at baseline to 6.0 L/min/m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at peak exercise (19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percentile specific for age and sex)</a:t>
            </a:r>
          </a:p>
          <a:p>
            <a:pPr algn="just"/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nvasive Coronary Angiography: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6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FR</a:t>
            </a:r>
            <a:r>
              <a:rPr lang="en-US" sz="1600" b="1" baseline="-250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LAD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0.86 (60% obstruction by visual assessment)</a:t>
            </a:r>
          </a:p>
        </p:txBody>
      </p:sp>
    </p:spTree>
    <p:extLst>
      <p:ext uri="{BB962C8B-B14F-4D97-AF65-F5344CB8AC3E}">
        <p14:creationId xmlns:p14="http://schemas.microsoft.com/office/powerpoint/2010/main" val="4279046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7</TotalTime>
  <Words>303</Words>
  <Application>Microsoft Macintosh PowerPoint</Application>
  <PresentationFormat>Widescreen</PresentationFormat>
  <Paragraphs>64</Paragraphs>
  <Slides>9</Slides>
  <Notes>0</Notes>
  <HiddenSlides>0</HiddenSlides>
  <MMClips>8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Online Supplementary  Multiparametric Exercise Stress Cardiovascular Magnetic Resonance in the Diagnosis of Coronary Artery Disease: The EMPIRE Trial </vt:lpstr>
      <vt:lpstr>Trial Profile Flow Chart</vt:lpstr>
      <vt:lpstr>Motion Correction (MOCO)</vt:lpstr>
      <vt:lpstr>FFR-positive Case </vt:lpstr>
      <vt:lpstr>FFR-positive Case </vt:lpstr>
      <vt:lpstr>FFR-positive Case </vt:lpstr>
      <vt:lpstr>FFR-normal Case </vt:lpstr>
      <vt:lpstr>FFR-normal Case 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nline Supplementary  Multiparametric Exercise Stress Cardiovascular Magnetic Resonance in the Diagnosis of Coronary Artery Disease: The EMPIRE Trial </dc:title>
  <dc:creator>Thao Le</dc:creator>
  <cp:lastModifiedBy>Thao Le</cp:lastModifiedBy>
  <cp:revision>2</cp:revision>
  <dcterms:created xsi:type="dcterms:W3CDTF">2020-09-22T05:19:45Z</dcterms:created>
  <dcterms:modified xsi:type="dcterms:W3CDTF">2020-11-03T01:46:12Z</dcterms:modified>
</cp:coreProperties>
</file>